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heme/theme2.xml" ContentType="application/vnd.openxmlformats-officedocument.theme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ags/tag66.xml" ContentType="application/vnd.openxmlformats-officedocument.presentationml.tags+xml"/>
  <Override PartName="/ppt/notesSlides/notesSlide1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72" r:id="rId2"/>
    <p:sldId id="277" r:id="rId3"/>
    <p:sldId id="257" r:id="rId4"/>
    <p:sldId id="275" r:id="rId5"/>
    <p:sldId id="270" r:id="rId6"/>
    <p:sldId id="276" r:id="rId7"/>
  </p:sldIdLst>
  <p:sldSz cx="9144000" cy="6858000" type="screen4x3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7" d="100"/>
          <a:sy n="97" d="100"/>
        </p:scale>
        <p:origin x="1128" y="72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tags" Target="tags/tag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ijms\&#23385;&#38663;-&#25991;&#31456;&#23454;&#39564;&#34917;&#2080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&#26611;&#26525;&#31287;&#28422;&#37238;\20220121LAC&#32452;&#32455;&#34920;&#36798;QRT&#25968;&#25454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&#26611;&#26525;&#31287;&#28422;&#37238;\20220121LAC&#32452;&#32455;&#34920;&#36798;QRT&#25968;&#25454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&#26611;&#26525;&#31287;&#28422;&#37238;\20220121LAC&#32452;&#32455;&#34920;&#36798;QRT&#25968;&#25454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ijms\&#23385;&#38663;-&#25991;&#31456;&#23454;&#39564;&#34917;&#20805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ijms\&#23385;&#38663;-&#25991;&#31456;&#23454;&#39564;&#34917;&#20805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ijms\&#23385;&#38663;-&#25991;&#31456;&#23454;&#39564;&#34917;&#20805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ijms\&#23385;&#38663;-&#25991;&#31456;&#23454;&#39564;&#34917;&#20805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&#26611;&#26525;&#31287;&#28422;&#37238;\20220121LAC&#32452;&#32455;&#34920;&#36798;QRT&#25968;&#25454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&#26611;&#26525;&#31287;&#28422;&#37238;\20220121LAC&#32452;&#32455;&#34920;&#36798;QRT&#25968;&#25454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&#26611;&#26525;&#31287;&#28422;&#37238;\20220121LAC&#32452;&#32455;&#34920;&#36798;QRT&#25968;&#25454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ostdoc\&#25991;&#31456;\Lac_lirui\&#26611;&#26525;&#31287;&#28422;&#37238;\20220121LAC&#32452;&#32455;&#34920;&#36798;QRT&#25968;&#25454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7!$B$9</c:f>
              <c:strCache>
                <c:ptCount val="1"/>
                <c:pt idx="0">
                  <c:v>PvLac17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C$13:$F$13</c:f>
                <c:numCache>
                  <c:formatCode>General</c:formatCode>
                  <c:ptCount val="4"/>
                  <c:pt idx="0">
                    <c:v>0.35380458596415348</c:v>
                  </c:pt>
                  <c:pt idx="1">
                    <c:v>0.57271221476080425</c:v>
                  </c:pt>
                  <c:pt idx="2">
                    <c:v>5.4052304517153296</c:v>
                  </c:pt>
                  <c:pt idx="3">
                    <c:v>0.63578827974669483</c:v>
                  </c:pt>
                </c:numCache>
              </c:numRef>
            </c:plus>
            <c:minus>
              <c:numRef>
                <c:f>Sheet7!$C$13:$F$13</c:f>
                <c:numCache>
                  <c:formatCode>General</c:formatCode>
                  <c:ptCount val="4"/>
                  <c:pt idx="0">
                    <c:v>0.35380458596415348</c:v>
                  </c:pt>
                  <c:pt idx="1">
                    <c:v>0.57271221476080425</c:v>
                  </c:pt>
                  <c:pt idx="2">
                    <c:v>5.4052304517153296</c:v>
                  </c:pt>
                  <c:pt idx="3">
                    <c:v>0.635788279746694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7!$C$7:$F$8</c:f>
              <c:multiLvlStrCache>
                <c:ptCount val="4"/>
                <c:lvl>
                  <c:pt idx="0">
                    <c:v>1h</c:v>
                  </c:pt>
                  <c:pt idx="1">
                    <c:v>4h</c:v>
                  </c:pt>
                  <c:pt idx="2">
                    <c:v>1h</c:v>
                  </c:pt>
                  <c:pt idx="3">
                    <c:v>4h</c:v>
                  </c:pt>
                </c:lvl>
                <c:lvl>
                  <c:pt idx="0">
                    <c:v>Cold</c:v>
                  </c:pt>
                  <c:pt idx="2">
                    <c:v>Drought</c:v>
                  </c:pt>
                </c:lvl>
              </c:multiLvlStrCache>
            </c:multiLvlStrRef>
          </c:cat>
          <c:val>
            <c:numRef>
              <c:f>Sheet7!$C$9:$F$9</c:f>
              <c:numCache>
                <c:formatCode>General</c:formatCode>
                <c:ptCount val="4"/>
                <c:pt idx="0">
                  <c:v>1.6446878965283043</c:v>
                </c:pt>
                <c:pt idx="1">
                  <c:v>3.0058877658174632</c:v>
                </c:pt>
                <c:pt idx="2">
                  <c:v>27.273177235687378</c:v>
                </c:pt>
                <c:pt idx="3">
                  <c:v>3.05866983382132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35-443B-A8B4-5F013E6C42B4}"/>
            </c:ext>
          </c:extLst>
        </c:ser>
        <c:ser>
          <c:idx val="1"/>
          <c:order val="1"/>
          <c:tx>
            <c:strRef>
              <c:f>Sheet7!$B$10</c:f>
              <c:strCache>
                <c:ptCount val="1"/>
                <c:pt idx="0">
                  <c:v>PvLac2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C$14:$F$14</c:f>
                <c:numCache>
                  <c:formatCode>General</c:formatCode>
                  <c:ptCount val="4"/>
                  <c:pt idx="0">
                    <c:v>2.1232897066704993E-2</c:v>
                  </c:pt>
                  <c:pt idx="1">
                    <c:v>0.2491482601426927</c:v>
                  </c:pt>
                  <c:pt idx="2">
                    <c:v>0.48001105825196122</c:v>
                  </c:pt>
                  <c:pt idx="3">
                    <c:v>1.5285864836511187</c:v>
                  </c:pt>
                </c:numCache>
              </c:numRef>
            </c:plus>
            <c:minus>
              <c:numRef>
                <c:f>Sheet7!$C$14:$F$14</c:f>
                <c:numCache>
                  <c:formatCode>General</c:formatCode>
                  <c:ptCount val="4"/>
                  <c:pt idx="0">
                    <c:v>2.1232897066704993E-2</c:v>
                  </c:pt>
                  <c:pt idx="1">
                    <c:v>0.2491482601426927</c:v>
                  </c:pt>
                  <c:pt idx="2">
                    <c:v>0.48001105825196122</c:v>
                  </c:pt>
                  <c:pt idx="3">
                    <c:v>1.52858648365111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7!$C$7:$F$8</c:f>
              <c:multiLvlStrCache>
                <c:ptCount val="4"/>
                <c:lvl>
                  <c:pt idx="0">
                    <c:v>1h</c:v>
                  </c:pt>
                  <c:pt idx="1">
                    <c:v>4h</c:v>
                  </c:pt>
                  <c:pt idx="2">
                    <c:v>1h</c:v>
                  </c:pt>
                  <c:pt idx="3">
                    <c:v>4h</c:v>
                  </c:pt>
                </c:lvl>
                <c:lvl>
                  <c:pt idx="0">
                    <c:v>Cold</c:v>
                  </c:pt>
                  <c:pt idx="2">
                    <c:v>Drought</c:v>
                  </c:pt>
                </c:lvl>
              </c:multiLvlStrCache>
            </c:multiLvlStrRef>
          </c:cat>
          <c:val>
            <c:numRef>
              <c:f>Sheet7!$C$10:$F$10</c:f>
              <c:numCache>
                <c:formatCode>General</c:formatCode>
                <c:ptCount val="4"/>
                <c:pt idx="0">
                  <c:v>0.86503296433089127</c:v>
                </c:pt>
                <c:pt idx="1">
                  <c:v>1.293614048791544</c:v>
                </c:pt>
                <c:pt idx="2">
                  <c:v>2.4734323648575804</c:v>
                </c:pt>
                <c:pt idx="3">
                  <c:v>5.91998023143675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335-443B-A8B4-5F013E6C42B4}"/>
            </c:ext>
          </c:extLst>
        </c:ser>
        <c:ser>
          <c:idx val="2"/>
          <c:order val="2"/>
          <c:tx>
            <c:strRef>
              <c:f>Sheet7!$B$11</c:f>
              <c:strCache>
                <c:ptCount val="1"/>
                <c:pt idx="0">
                  <c:v>PvLac1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C$15:$F$15</c:f>
                <c:numCache>
                  <c:formatCode>General</c:formatCode>
                  <c:ptCount val="4"/>
                  <c:pt idx="0">
                    <c:v>0.16248275500422177</c:v>
                  </c:pt>
                  <c:pt idx="1">
                    <c:v>0.10394020785187777</c:v>
                  </c:pt>
                  <c:pt idx="2">
                    <c:v>0.14678630817697358</c:v>
                  </c:pt>
                  <c:pt idx="3">
                    <c:v>0.28471598920677349</c:v>
                  </c:pt>
                </c:numCache>
              </c:numRef>
            </c:plus>
            <c:minus>
              <c:numRef>
                <c:f>Sheet7!$C$15:$F$15</c:f>
                <c:numCache>
                  <c:formatCode>General</c:formatCode>
                  <c:ptCount val="4"/>
                  <c:pt idx="0">
                    <c:v>0.16248275500422177</c:v>
                  </c:pt>
                  <c:pt idx="1">
                    <c:v>0.10394020785187777</c:v>
                  </c:pt>
                  <c:pt idx="2">
                    <c:v>0.14678630817697358</c:v>
                  </c:pt>
                  <c:pt idx="3">
                    <c:v>0.284715989206773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7!$C$7:$F$8</c:f>
              <c:multiLvlStrCache>
                <c:ptCount val="4"/>
                <c:lvl>
                  <c:pt idx="0">
                    <c:v>1h</c:v>
                  </c:pt>
                  <c:pt idx="1">
                    <c:v>4h</c:v>
                  </c:pt>
                  <c:pt idx="2">
                    <c:v>1h</c:v>
                  </c:pt>
                  <c:pt idx="3">
                    <c:v>4h</c:v>
                  </c:pt>
                </c:lvl>
                <c:lvl>
                  <c:pt idx="0">
                    <c:v>Cold</c:v>
                  </c:pt>
                  <c:pt idx="2">
                    <c:v>Drought</c:v>
                  </c:pt>
                </c:lvl>
              </c:multiLvlStrCache>
            </c:multiLvlStrRef>
          </c:cat>
          <c:val>
            <c:numRef>
              <c:f>Sheet7!$C$11:$F$11</c:f>
              <c:numCache>
                <c:formatCode>General</c:formatCode>
                <c:ptCount val="4"/>
                <c:pt idx="0">
                  <c:v>1.2164259764276615</c:v>
                </c:pt>
                <c:pt idx="1">
                  <c:v>0.78288630096949774</c:v>
                </c:pt>
                <c:pt idx="2">
                  <c:v>1.2275250404197426</c:v>
                </c:pt>
                <c:pt idx="3">
                  <c:v>0.931518688047151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335-443B-A8B4-5F013E6C42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059483151"/>
        <c:axId val="2059483567"/>
      </c:barChart>
      <c:catAx>
        <c:axId val="205948315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9483567"/>
        <c:crosses val="autoZero"/>
        <c:auto val="1"/>
        <c:lblAlgn val="ctr"/>
        <c:lblOffset val="100"/>
        <c:noMultiLvlLbl val="0"/>
      </c:catAx>
      <c:valAx>
        <c:axId val="205948356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change fold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9483151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41741666666666671"/>
          <c:y val="6.8591837301183414E-2"/>
          <c:w val="0.52616141732283461"/>
          <c:h val="9.004506046614912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7</c:f>
              <c:strCache>
                <c:ptCount val="1"/>
                <c:pt idx="0">
                  <c:v>PvLac24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B$17:$M$17</c:f>
                <c:numCache>
                  <c:formatCode>General</c:formatCode>
                  <c:ptCount val="12"/>
                  <c:pt idx="0">
                    <c:v>2.1279148822740599E-2</c:v>
                  </c:pt>
                  <c:pt idx="1">
                    <c:v>1.09801674545002E-2</c:v>
                  </c:pt>
                  <c:pt idx="2">
                    <c:v>9.1267044910961301E-3</c:v>
                  </c:pt>
                  <c:pt idx="3">
                    <c:v>4.3064566196826196E-3</c:v>
                  </c:pt>
                  <c:pt idx="4">
                    <c:v>5.9015541840283398E-8</c:v>
                  </c:pt>
                  <c:pt idx="5">
                    <c:v>6.5985320487673903E-7</c:v>
                  </c:pt>
                  <c:pt idx="6">
                    <c:v>1.5609273837826501E-6</c:v>
                  </c:pt>
                  <c:pt idx="7">
                    <c:v>1.0887572315164299E-5</c:v>
                  </c:pt>
                  <c:pt idx="8">
                    <c:v>6.6802757007860798E-4</c:v>
                  </c:pt>
                  <c:pt idx="9">
                    <c:v>3.1949177544381E-4</c:v>
                  </c:pt>
                  <c:pt idx="10">
                    <c:v>4.5034560672209899E-4</c:v>
                  </c:pt>
                  <c:pt idx="11">
                    <c:v>2.4547340540403501E-4</c:v>
                  </c:pt>
                </c:numCache>
              </c:numRef>
            </c:plus>
            <c:minus>
              <c:numRef>
                <c:f>Sheet3!$B$17:$M$17</c:f>
                <c:numCache>
                  <c:formatCode>General</c:formatCode>
                  <c:ptCount val="12"/>
                  <c:pt idx="0">
                    <c:v>2.1279148822740599E-2</c:v>
                  </c:pt>
                  <c:pt idx="1">
                    <c:v>1.09801674545002E-2</c:v>
                  </c:pt>
                  <c:pt idx="2">
                    <c:v>9.1267044910961301E-3</c:v>
                  </c:pt>
                  <c:pt idx="3">
                    <c:v>4.3064566196826196E-3</c:v>
                  </c:pt>
                  <c:pt idx="4">
                    <c:v>5.9015541840283398E-8</c:v>
                  </c:pt>
                  <c:pt idx="5">
                    <c:v>6.5985320487673903E-7</c:v>
                  </c:pt>
                  <c:pt idx="6">
                    <c:v>1.5609273837826501E-6</c:v>
                  </c:pt>
                  <c:pt idx="7">
                    <c:v>1.0887572315164299E-5</c:v>
                  </c:pt>
                  <c:pt idx="8">
                    <c:v>6.6802757007860798E-4</c:v>
                  </c:pt>
                  <c:pt idx="9">
                    <c:v>3.1949177544381E-4</c:v>
                  </c:pt>
                  <c:pt idx="10">
                    <c:v>4.5034560672209899E-4</c:v>
                  </c:pt>
                  <c:pt idx="11">
                    <c:v>2.4547340540403501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B$2:$M$3</c:f>
              <c:strCache>
                <c:ptCount val="12"/>
                <c:pt idx="0">
                  <c:v>E4I1</c:v>
                </c:pt>
                <c:pt idx="1">
                  <c:v>E4I2</c:v>
                </c:pt>
                <c:pt idx="2">
                  <c:v>E4I3</c:v>
                </c:pt>
                <c:pt idx="3">
                  <c:v>E4I4</c:v>
                </c:pt>
                <c:pt idx="4">
                  <c:v>E4L1</c:v>
                </c:pt>
                <c:pt idx="5">
                  <c:v>E4L2</c:v>
                </c:pt>
                <c:pt idx="6">
                  <c:v>E4L3</c:v>
                </c:pt>
                <c:pt idx="7">
                  <c:v>E4L4</c:v>
                </c:pt>
                <c:pt idx="8">
                  <c:v>E4LS1</c:v>
                </c:pt>
                <c:pt idx="9">
                  <c:v>E4LS2</c:v>
                </c:pt>
                <c:pt idx="10">
                  <c:v>E4LS3</c:v>
                </c:pt>
                <c:pt idx="11">
                  <c:v>E4LS4</c:v>
                </c:pt>
              </c:strCache>
            </c:strRef>
          </c:cat>
          <c:val>
            <c:numRef>
              <c:f>Sheet3!$B$7:$M$7</c:f>
              <c:numCache>
                <c:formatCode>General</c:formatCode>
                <c:ptCount val="12"/>
                <c:pt idx="0">
                  <c:v>0.179270835720308</c:v>
                </c:pt>
                <c:pt idx="1">
                  <c:v>0.101956031031711</c:v>
                </c:pt>
                <c:pt idx="2">
                  <c:v>0.115429183271802</c:v>
                </c:pt>
                <c:pt idx="3">
                  <c:v>2.1652067109606401E-2</c:v>
                </c:pt>
                <c:pt idx="4">
                  <c:v>4.4509695036131996E-6</c:v>
                </c:pt>
                <c:pt idx="5">
                  <c:v>1.0712351905784999E-5</c:v>
                </c:pt>
                <c:pt idx="6">
                  <c:v>1.1660330178061201E-5</c:v>
                </c:pt>
                <c:pt idx="7">
                  <c:v>3.5807969309974101E-5</c:v>
                </c:pt>
                <c:pt idx="8">
                  <c:v>2.3061587027696099E-3</c:v>
                </c:pt>
                <c:pt idx="9">
                  <c:v>1.52559952065873E-3</c:v>
                </c:pt>
                <c:pt idx="10">
                  <c:v>1.47803015947356E-3</c:v>
                </c:pt>
                <c:pt idx="11">
                  <c:v>2.0498196584177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CB-4025-AAC5-A0071EFDDE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714160"/>
        <c:axId val="793734960"/>
      </c:barChart>
      <c:catAx>
        <c:axId val="7937141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Segments from</a:t>
                </a:r>
                <a:r>
                  <a:rPr lang="en-US" altLang="zh-CN" sz="1200" baseline="0"/>
                  <a:t> E4 stage switchgrass</a:t>
                </a:r>
                <a:endParaRPr lang="zh-CN" altLang="en-US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34960"/>
        <c:crosses val="autoZero"/>
        <c:auto val="1"/>
        <c:lblAlgn val="ctr"/>
        <c:lblOffset val="100"/>
        <c:noMultiLvlLbl val="0"/>
      </c:catAx>
      <c:valAx>
        <c:axId val="793734960"/>
        <c:scaling>
          <c:orientation val="minMax"/>
          <c:max val="0.2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of </a:t>
                </a:r>
              </a:p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 i="1" baseline="0"/>
                  <a:t>PvLac24</a:t>
                </a:r>
                <a:endParaRPr lang="zh-CN" altLang="en-US" sz="1200" i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14160"/>
        <c:crosses val="autoZero"/>
        <c:crossBetween val="between"/>
        <c:majorUnit val="0.06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00">
          <a:latin typeface="Times New Roman" panose="02020603050405020304" charset="0"/>
          <a:cs typeface="Times New Roman" panose="0202060305040502030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8</c:f>
              <c:strCache>
                <c:ptCount val="1"/>
                <c:pt idx="0">
                  <c:v>PvLac35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B$18:$M$18</c:f>
                <c:numCache>
                  <c:formatCode>General</c:formatCode>
                  <c:ptCount val="12"/>
                  <c:pt idx="0">
                    <c:v>4.98833952510384E-4</c:v>
                  </c:pt>
                  <c:pt idx="1">
                    <c:v>3.2074701393116798E-4</c:v>
                  </c:pt>
                  <c:pt idx="2">
                    <c:v>1.34323023624049E-5</c:v>
                  </c:pt>
                  <c:pt idx="3">
                    <c:v>2.8071485484724599E-4</c:v>
                  </c:pt>
                  <c:pt idx="4">
                    <c:v>5.9360000322803905E-4</c:v>
                  </c:pt>
                  <c:pt idx="5">
                    <c:v>5.4892913980825902E-4</c:v>
                  </c:pt>
                  <c:pt idx="6">
                    <c:v>6.7933946411692398E-4</c:v>
                  </c:pt>
                  <c:pt idx="7">
                    <c:v>5.23275002566598E-4</c:v>
                  </c:pt>
                  <c:pt idx="8">
                    <c:v>7.6034282588698993E-5</c:v>
                  </c:pt>
                  <c:pt idx="9">
                    <c:v>5.6711946523378795E-4</c:v>
                  </c:pt>
                  <c:pt idx="10">
                    <c:v>3.1832674909291201E-4</c:v>
                  </c:pt>
                  <c:pt idx="11">
                    <c:v>2.1397091742449801E-4</c:v>
                  </c:pt>
                </c:numCache>
              </c:numRef>
            </c:plus>
            <c:minus>
              <c:numRef>
                <c:f>Sheet3!$B$18:$M$18</c:f>
                <c:numCache>
                  <c:formatCode>General</c:formatCode>
                  <c:ptCount val="12"/>
                  <c:pt idx="0">
                    <c:v>4.98833952510384E-4</c:v>
                  </c:pt>
                  <c:pt idx="1">
                    <c:v>3.2074701393116798E-4</c:v>
                  </c:pt>
                  <c:pt idx="2">
                    <c:v>1.34323023624049E-5</c:v>
                  </c:pt>
                  <c:pt idx="3">
                    <c:v>2.8071485484724599E-4</c:v>
                  </c:pt>
                  <c:pt idx="4">
                    <c:v>5.9360000322803905E-4</c:v>
                  </c:pt>
                  <c:pt idx="5">
                    <c:v>5.4892913980825902E-4</c:v>
                  </c:pt>
                  <c:pt idx="6">
                    <c:v>6.7933946411692398E-4</c:v>
                  </c:pt>
                  <c:pt idx="7">
                    <c:v>5.23275002566598E-4</c:v>
                  </c:pt>
                  <c:pt idx="8">
                    <c:v>7.6034282588698993E-5</c:v>
                  </c:pt>
                  <c:pt idx="9">
                    <c:v>5.6711946523378795E-4</c:v>
                  </c:pt>
                  <c:pt idx="10">
                    <c:v>3.1832674909291201E-4</c:v>
                  </c:pt>
                  <c:pt idx="11">
                    <c:v>2.1397091742449801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B$2:$M$3</c:f>
              <c:strCache>
                <c:ptCount val="12"/>
                <c:pt idx="0">
                  <c:v>E4I1</c:v>
                </c:pt>
                <c:pt idx="1">
                  <c:v>E4I2</c:v>
                </c:pt>
                <c:pt idx="2">
                  <c:v>E4I3</c:v>
                </c:pt>
                <c:pt idx="3">
                  <c:v>E4I4</c:v>
                </c:pt>
                <c:pt idx="4">
                  <c:v>E4L1</c:v>
                </c:pt>
                <c:pt idx="5">
                  <c:v>E4L2</c:v>
                </c:pt>
                <c:pt idx="6">
                  <c:v>E4L3</c:v>
                </c:pt>
                <c:pt idx="7">
                  <c:v>E4L4</c:v>
                </c:pt>
                <c:pt idx="8">
                  <c:v>E4LS1</c:v>
                </c:pt>
                <c:pt idx="9">
                  <c:v>E4LS2</c:v>
                </c:pt>
                <c:pt idx="10">
                  <c:v>E4LS3</c:v>
                </c:pt>
                <c:pt idx="11">
                  <c:v>E4LS4</c:v>
                </c:pt>
              </c:strCache>
            </c:strRef>
          </c:cat>
          <c:val>
            <c:numRef>
              <c:f>Sheet3!$B$8:$M$8</c:f>
              <c:numCache>
                <c:formatCode>General</c:formatCode>
                <c:ptCount val="12"/>
                <c:pt idx="0">
                  <c:v>3.27289505832851E-3</c:v>
                </c:pt>
                <c:pt idx="1">
                  <c:v>8.8689365213518096E-4</c:v>
                </c:pt>
                <c:pt idx="2">
                  <c:v>3.5555096861002801E-4</c:v>
                </c:pt>
                <c:pt idx="3">
                  <c:v>1.6110339469858901E-3</c:v>
                </c:pt>
                <c:pt idx="4">
                  <c:v>1.9932684957490901E-3</c:v>
                </c:pt>
                <c:pt idx="5">
                  <c:v>1.6195278019873699E-3</c:v>
                </c:pt>
                <c:pt idx="6">
                  <c:v>2.41690949051236E-3</c:v>
                </c:pt>
                <c:pt idx="7">
                  <c:v>2.0131603033618499E-3</c:v>
                </c:pt>
                <c:pt idx="8">
                  <c:v>1.55140870523106E-3</c:v>
                </c:pt>
                <c:pt idx="9">
                  <c:v>1.96285887441299E-3</c:v>
                </c:pt>
                <c:pt idx="10">
                  <c:v>2.9294244702362101E-3</c:v>
                </c:pt>
                <c:pt idx="11">
                  <c:v>2.5037078508187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B5-4C46-B245-EB33A66F1C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714160"/>
        <c:axId val="793734960"/>
      </c:barChart>
      <c:catAx>
        <c:axId val="7937141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Segments from</a:t>
                </a:r>
                <a:r>
                  <a:rPr lang="en-US" altLang="zh-CN" sz="1200" baseline="0"/>
                  <a:t> E4 stage switchgrass</a:t>
                </a:r>
                <a:endParaRPr lang="zh-CN" altLang="en-US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34960"/>
        <c:crosses val="autoZero"/>
        <c:auto val="1"/>
        <c:lblAlgn val="ctr"/>
        <c:lblOffset val="100"/>
        <c:noMultiLvlLbl val="0"/>
      </c:catAx>
      <c:valAx>
        <c:axId val="793734960"/>
        <c:scaling>
          <c:orientation val="minMax"/>
          <c:max val="4.0000000000000001E-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of </a:t>
                </a:r>
              </a:p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 i="1" baseline="0"/>
                  <a:t>PvLac35</a:t>
                </a:r>
                <a:endParaRPr lang="zh-CN" altLang="en-US" sz="1200" i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14160"/>
        <c:crosses val="autoZero"/>
        <c:crossBetween val="between"/>
        <c:majorUnit val="1E-3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00">
          <a:latin typeface="Times New Roman" panose="02020603050405020304" charset="0"/>
          <a:cs typeface="Times New Roman" panose="0202060305040502030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10</c:f>
              <c:strCache>
                <c:ptCount val="1"/>
                <c:pt idx="0">
                  <c:v>PvCCoAOM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B$20:$M$20</c:f>
                <c:numCache>
                  <c:formatCode>General</c:formatCode>
                  <c:ptCount val="12"/>
                  <c:pt idx="0">
                    <c:v>2.9828154278047601E-4</c:v>
                  </c:pt>
                  <c:pt idx="1">
                    <c:v>1.09862986728899E-3</c:v>
                  </c:pt>
                  <c:pt idx="2">
                    <c:v>1.75702135858718E-3</c:v>
                  </c:pt>
                  <c:pt idx="3">
                    <c:v>1.2198065103610301E-3</c:v>
                  </c:pt>
                  <c:pt idx="4">
                    <c:v>1.12539838895016E-4</c:v>
                  </c:pt>
                  <c:pt idx="5">
                    <c:v>1.07079854818793E-4</c:v>
                  </c:pt>
                  <c:pt idx="6">
                    <c:v>1.49135837096621E-4</c:v>
                  </c:pt>
                  <c:pt idx="7">
                    <c:v>1.18134802453855E-4</c:v>
                  </c:pt>
                  <c:pt idx="8">
                    <c:v>3.8601170924166498E-4</c:v>
                  </c:pt>
                  <c:pt idx="9">
                    <c:v>4.1560462923569602E-4</c:v>
                  </c:pt>
                  <c:pt idx="10">
                    <c:v>2.8025178906515601E-4</c:v>
                  </c:pt>
                  <c:pt idx="11">
                    <c:v>2.10428869074039E-4</c:v>
                  </c:pt>
                </c:numCache>
              </c:numRef>
            </c:plus>
            <c:minus>
              <c:numRef>
                <c:f>Sheet3!$B$20:$M$20</c:f>
                <c:numCache>
                  <c:formatCode>General</c:formatCode>
                  <c:ptCount val="12"/>
                  <c:pt idx="0">
                    <c:v>2.9828154278047601E-4</c:v>
                  </c:pt>
                  <c:pt idx="1">
                    <c:v>1.09862986728899E-3</c:v>
                  </c:pt>
                  <c:pt idx="2">
                    <c:v>1.75702135858718E-3</c:v>
                  </c:pt>
                  <c:pt idx="3">
                    <c:v>1.2198065103610301E-3</c:v>
                  </c:pt>
                  <c:pt idx="4">
                    <c:v>1.12539838895016E-4</c:v>
                  </c:pt>
                  <c:pt idx="5">
                    <c:v>1.07079854818793E-4</c:v>
                  </c:pt>
                  <c:pt idx="6">
                    <c:v>1.49135837096621E-4</c:v>
                  </c:pt>
                  <c:pt idx="7">
                    <c:v>1.18134802453855E-4</c:v>
                  </c:pt>
                  <c:pt idx="8">
                    <c:v>3.8601170924166498E-4</c:v>
                  </c:pt>
                  <c:pt idx="9">
                    <c:v>4.1560462923569602E-4</c:v>
                  </c:pt>
                  <c:pt idx="10">
                    <c:v>2.8025178906515601E-4</c:v>
                  </c:pt>
                  <c:pt idx="11">
                    <c:v>2.10428869074039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B$2:$M$3</c:f>
              <c:strCache>
                <c:ptCount val="12"/>
                <c:pt idx="0">
                  <c:v>E4I1</c:v>
                </c:pt>
                <c:pt idx="1">
                  <c:v>E4I2</c:v>
                </c:pt>
                <c:pt idx="2">
                  <c:v>E4I3</c:v>
                </c:pt>
                <c:pt idx="3">
                  <c:v>E4I4</c:v>
                </c:pt>
                <c:pt idx="4">
                  <c:v>E4L1</c:v>
                </c:pt>
                <c:pt idx="5">
                  <c:v>E4L2</c:v>
                </c:pt>
                <c:pt idx="6">
                  <c:v>E4L3</c:v>
                </c:pt>
                <c:pt idx="7">
                  <c:v>E4L4</c:v>
                </c:pt>
                <c:pt idx="8">
                  <c:v>E4LS1</c:v>
                </c:pt>
                <c:pt idx="9">
                  <c:v>E4LS2</c:v>
                </c:pt>
                <c:pt idx="10">
                  <c:v>E4LS3</c:v>
                </c:pt>
                <c:pt idx="11">
                  <c:v>E4LS4</c:v>
                </c:pt>
              </c:strCache>
            </c:strRef>
          </c:cat>
          <c:val>
            <c:numRef>
              <c:f>Sheet3!$B$10:$M$10</c:f>
              <c:numCache>
                <c:formatCode>General</c:formatCode>
                <c:ptCount val="12"/>
                <c:pt idx="0">
                  <c:v>2.6531215385305201E-2</c:v>
                </c:pt>
                <c:pt idx="1">
                  <c:v>1.61866207258076E-2</c:v>
                </c:pt>
                <c:pt idx="2">
                  <c:v>1.6311867971874599E-2</c:v>
                </c:pt>
                <c:pt idx="3">
                  <c:v>1.7956478811816799E-2</c:v>
                </c:pt>
                <c:pt idx="4">
                  <c:v>1.51248359788527E-3</c:v>
                </c:pt>
                <c:pt idx="5">
                  <c:v>1.3787932825743E-3</c:v>
                </c:pt>
                <c:pt idx="6">
                  <c:v>1.1199491903231299E-3</c:v>
                </c:pt>
                <c:pt idx="7">
                  <c:v>1.25059369701934E-3</c:v>
                </c:pt>
                <c:pt idx="8">
                  <c:v>7.5948649865207E-3</c:v>
                </c:pt>
                <c:pt idx="9">
                  <c:v>4.4850936738589104E-3</c:v>
                </c:pt>
                <c:pt idx="10">
                  <c:v>4.69650671313425E-3</c:v>
                </c:pt>
                <c:pt idx="11">
                  <c:v>4.721865159922869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97-4853-84E3-677550B2F7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714160"/>
        <c:axId val="793734960"/>
      </c:barChart>
      <c:catAx>
        <c:axId val="793714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34960"/>
        <c:crosses val="autoZero"/>
        <c:auto val="1"/>
        <c:lblAlgn val="ctr"/>
        <c:lblOffset val="100"/>
        <c:noMultiLvlLbl val="0"/>
      </c:catAx>
      <c:valAx>
        <c:axId val="793734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of </a:t>
                </a:r>
                <a:r>
                  <a:rPr lang="en-US" altLang="zh-CN" sz="1200" i="1" baseline="0"/>
                  <a:t>PvCCoAOMT</a:t>
                </a:r>
                <a:endParaRPr lang="zh-CN" altLang="en-US" sz="1200" i="1"/>
              </a:p>
            </c:rich>
          </c:tx>
          <c:layout>
            <c:manualLayout>
              <c:xMode val="edge"/>
              <c:yMode val="edge"/>
              <c:x val="3.8888888888888903E-2"/>
              <c:y val="0.150023813651334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14160"/>
        <c:crosses val="autoZero"/>
        <c:crossBetween val="between"/>
        <c:majorUnit val="0.0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00">
          <a:latin typeface="Times New Roman" panose="02020603050405020304" charset="0"/>
          <a:cs typeface="Times New Roman" panose="0202060305040502030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B$43</c:f>
              <c:strCache>
                <c:ptCount val="1"/>
                <c:pt idx="0">
                  <c:v>LAC1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M$43:$U$43</c:f>
                <c:numCache>
                  <c:formatCode>General</c:formatCode>
                  <c:ptCount val="9"/>
                  <c:pt idx="0">
                    <c:v>0.48314559905691057</c:v>
                  </c:pt>
                  <c:pt idx="1">
                    <c:v>1.8642272434364306</c:v>
                  </c:pt>
                  <c:pt idx="2">
                    <c:v>3.2400574911550538E-2</c:v>
                  </c:pt>
                  <c:pt idx="3">
                    <c:v>0.12691974848741355</c:v>
                  </c:pt>
                  <c:pt idx="4">
                    <c:v>0.57809166775080811</c:v>
                  </c:pt>
                  <c:pt idx="5">
                    <c:v>0.57621278403882659</c:v>
                  </c:pt>
                  <c:pt idx="6">
                    <c:v>0.43431175338945927</c:v>
                  </c:pt>
                  <c:pt idx="7">
                    <c:v>8.6583577478545254E-2</c:v>
                  </c:pt>
                  <c:pt idx="8">
                    <c:v>0.16960827476191026</c:v>
                  </c:pt>
                </c:numCache>
              </c:numRef>
            </c:plus>
            <c:minus>
              <c:numRef>
                <c:f>Sheet7!$M$43:$U$43</c:f>
                <c:numCache>
                  <c:formatCode>General</c:formatCode>
                  <c:ptCount val="9"/>
                  <c:pt idx="0">
                    <c:v>0.48314559905691057</c:v>
                  </c:pt>
                  <c:pt idx="1">
                    <c:v>1.8642272434364306</c:v>
                  </c:pt>
                  <c:pt idx="2">
                    <c:v>3.2400574911550538E-2</c:v>
                  </c:pt>
                  <c:pt idx="3">
                    <c:v>0.12691974848741355</c:v>
                  </c:pt>
                  <c:pt idx="4">
                    <c:v>0.57809166775080811</c:v>
                  </c:pt>
                  <c:pt idx="5">
                    <c:v>0.57621278403882659</c:v>
                  </c:pt>
                  <c:pt idx="6">
                    <c:v>0.43431175338945927</c:v>
                  </c:pt>
                  <c:pt idx="7">
                    <c:v>8.6583577478545254E-2</c:v>
                  </c:pt>
                  <c:pt idx="8">
                    <c:v>0.169608274761910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7!$C$41:$K$42</c:f>
              <c:multiLvlStrCache>
                <c:ptCount val="9"/>
                <c:lvl>
                  <c:pt idx="1">
                    <c:v>100 mM</c:v>
                  </c:pt>
                  <c:pt idx="2">
                    <c:v>500 mM</c:v>
                  </c:pt>
                  <c:pt idx="3">
                    <c:v>100 mM</c:v>
                  </c:pt>
                  <c:pt idx="4">
                    <c:v>500 mM</c:v>
                  </c:pt>
                  <c:pt idx="5">
                    <c:v>100 mM</c:v>
                  </c:pt>
                  <c:pt idx="6">
                    <c:v>500 mM</c:v>
                  </c:pt>
                  <c:pt idx="7">
                    <c:v>100 mM</c:v>
                  </c:pt>
                  <c:pt idx="8">
                    <c:v>500 mM</c:v>
                  </c:pt>
                </c:lvl>
                <c:lvl>
                  <c:pt idx="0">
                    <c:v>Mock</c:v>
                  </c:pt>
                  <c:pt idx="1">
                    <c:v>Cu</c:v>
                  </c:pt>
                  <c:pt idx="3">
                    <c:v>Ni </c:v>
                  </c:pt>
                  <c:pt idx="5">
                    <c:v>Fe</c:v>
                  </c:pt>
                  <c:pt idx="7">
                    <c:v>Cd</c:v>
                  </c:pt>
                </c:lvl>
              </c:multiLvlStrCache>
            </c:multiLvlStrRef>
          </c:cat>
          <c:val>
            <c:numRef>
              <c:f>Sheet7!$C$43:$K$43</c:f>
              <c:numCache>
                <c:formatCode>General</c:formatCode>
                <c:ptCount val="9"/>
                <c:pt idx="0">
                  <c:v>6.1148770945170661</c:v>
                </c:pt>
                <c:pt idx="1">
                  <c:v>9.2447058120083589</c:v>
                </c:pt>
                <c:pt idx="2">
                  <c:v>0.44311834139364953</c:v>
                </c:pt>
                <c:pt idx="3">
                  <c:v>0.78503334933090962</c:v>
                </c:pt>
                <c:pt idx="4">
                  <c:v>4.3637054939669744</c:v>
                </c:pt>
                <c:pt idx="5">
                  <c:v>3.050522500691025</c:v>
                </c:pt>
                <c:pt idx="6">
                  <c:v>1.5209831655454156</c:v>
                </c:pt>
                <c:pt idx="7">
                  <c:v>0.59890244904876833</c:v>
                </c:pt>
                <c:pt idx="8">
                  <c:v>1.35937338518273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83-4D18-A87F-1441165AC0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2646207"/>
        <c:axId val="2082647039"/>
      </c:barChart>
      <c:catAx>
        <c:axId val="2082646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7039"/>
        <c:crosses val="autoZero"/>
        <c:auto val="1"/>
        <c:lblAlgn val="ctr"/>
        <c:lblOffset val="100"/>
        <c:noMultiLvlLbl val="0"/>
      </c:catAx>
      <c:valAx>
        <c:axId val="20826470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Normalized</a:t>
                </a:r>
                <a:r>
                  <a:rPr lang="en-US" altLang="zh-CN" baseline="0"/>
                  <a:t> expression level of </a:t>
                </a:r>
                <a:r>
                  <a:rPr lang="en-US" altLang="zh-CN" i="1" baseline="0"/>
                  <a:t>PvLac16</a:t>
                </a:r>
                <a:endParaRPr lang="zh-CN" altLang="en-US" i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6207"/>
        <c:crosses val="autoZero"/>
        <c:crossBetween val="between"/>
        <c:majorUnit val="3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B$44</c:f>
              <c:strCache>
                <c:ptCount val="1"/>
                <c:pt idx="0">
                  <c:v>LAC2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M$44:$U$44</c:f>
                <c:numCache>
                  <c:formatCode>General</c:formatCode>
                  <c:ptCount val="9"/>
                  <c:pt idx="0">
                    <c:v>0.47311065521407514</c:v>
                  </c:pt>
                  <c:pt idx="1">
                    <c:v>1.7801297488861436</c:v>
                  </c:pt>
                  <c:pt idx="2">
                    <c:v>0.1908835118551499</c:v>
                  </c:pt>
                  <c:pt idx="3">
                    <c:v>8.4554485021374456E-2</c:v>
                  </c:pt>
                  <c:pt idx="4">
                    <c:v>0.8145583131327343</c:v>
                  </c:pt>
                  <c:pt idx="5">
                    <c:v>0.87302496655349382</c:v>
                  </c:pt>
                  <c:pt idx="6">
                    <c:v>0.4831989937388555</c:v>
                  </c:pt>
                  <c:pt idx="7">
                    <c:v>0.85813479734488762</c:v>
                  </c:pt>
                  <c:pt idx="8">
                    <c:v>0.2184896073828449</c:v>
                  </c:pt>
                </c:numCache>
              </c:numRef>
            </c:plus>
            <c:minus>
              <c:numRef>
                <c:f>Sheet7!$M$44:$U$44</c:f>
                <c:numCache>
                  <c:formatCode>General</c:formatCode>
                  <c:ptCount val="9"/>
                  <c:pt idx="0">
                    <c:v>0.47311065521407514</c:v>
                  </c:pt>
                  <c:pt idx="1">
                    <c:v>1.7801297488861436</c:v>
                  </c:pt>
                  <c:pt idx="2">
                    <c:v>0.1908835118551499</c:v>
                  </c:pt>
                  <c:pt idx="3">
                    <c:v>8.4554485021374456E-2</c:v>
                  </c:pt>
                  <c:pt idx="4">
                    <c:v>0.8145583131327343</c:v>
                  </c:pt>
                  <c:pt idx="5">
                    <c:v>0.87302496655349382</c:v>
                  </c:pt>
                  <c:pt idx="6">
                    <c:v>0.4831989937388555</c:v>
                  </c:pt>
                  <c:pt idx="7">
                    <c:v>0.85813479734488762</c:v>
                  </c:pt>
                  <c:pt idx="8">
                    <c:v>0.21848960738284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7!$C$41:$K$42</c:f>
              <c:multiLvlStrCache>
                <c:ptCount val="9"/>
                <c:lvl>
                  <c:pt idx="1">
                    <c:v>100 mM</c:v>
                  </c:pt>
                  <c:pt idx="2">
                    <c:v>500 mM</c:v>
                  </c:pt>
                  <c:pt idx="3">
                    <c:v>100 mM</c:v>
                  </c:pt>
                  <c:pt idx="4">
                    <c:v>500 mM</c:v>
                  </c:pt>
                  <c:pt idx="5">
                    <c:v>100 mM</c:v>
                  </c:pt>
                  <c:pt idx="6">
                    <c:v>500 mM</c:v>
                  </c:pt>
                  <c:pt idx="7">
                    <c:v>100 mM</c:v>
                  </c:pt>
                  <c:pt idx="8">
                    <c:v>500 mM</c:v>
                  </c:pt>
                </c:lvl>
                <c:lvl>
                  <c:pt idx="0">
                    <c:v>Mock</c:v>
                  </c:pt>
                  <c:pt idx="1">
                    <c:v>Cu</c:v>
                  </c:pt>
                  <c:pt idx="3">
                    <c:v>Ni </c:v>
                  </c:pt>
                  <c:pt idx="5">
                    <c:v>Fe</c:v>
                  </c:pt>
                  <c:pt idx="7">
                    <c:v>Cd</c:v>
                  </c:pt>
                </c:lvl>
              </c:multiLvlStrCache>
            </c:multiLvlStrRef>
          </c:cat>
          <c:val>
            <c:numRef>
              <c:f>Sheet7!$C$44:$K$44</c:f>
              <c:numCache>
                <c:formatCode>General</c:formatCode>
                <c:ptCount val="9"/>
                <c:pt idx="0">
                  <c:v>3.5594130233771852</c:v>
                </c:pt>
                <c:pt idx="1">
                  <c:v>10.184127044645816</c:v>
                </c:pt>
                <c:pt idx="2">
                  <c:v>2.5435239997189605</c:v>
                </c:pt>
                <c:pt idx="3">
                  <c:v>0.79257313884747893</c:v>
                </c:pt>
                <c:pt idx="4">
                  <c:v>4.898974573084355</c:v>
                </c:pt>
                <c:pt idx="5">
                  <c:v>6.3181878423776325</c:v>
                </c:pt>
                <c:pt idx="6">
                  <c:v>1.6886039069982575</c:v>
                </c:pt>
                <c:pt idx="7">
                  <c:v>4.1519715623615081</c:v>
                </c:pt>
                <c:pt idx="8">
                  <c:v>1.66736496368809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1F-4892-8874-567A55A2C4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2646207"/>
        <c:axId val="2082647039"/>
      </c:barChart>
      <c:catAx>
        <c:axId val="2082646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7039"/>
        <c:crosses val="autoZero"/>
        <c:auto val="1"/>
        <c:lblAlgn val="ctr"/>
        <c:lblOffset val="100"/>
        <c:noMultiLvlLbl val="0"/>
      </c:catAx>
      <c:valAx>
        <c:axId val="2082647039"/>
        <c:scaling>
          <c:orientation val="minMax"/>
          <c:max val="1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Normalized</a:t>
                </a:r>
                <a:r>
                  <a:rPr lang="en-US" altLang="zh-CN" baseline="0"/>
                  <a:t> expression level of </a:t>
                </a:r>
                <a:r>
                  <a:rPr lang="en-US" altLang="zh-CN" i="1" baseline="0"/>
                  <a:t>PvLac25</a:t>
                </a:r>
                <a:endParaRPr lang="zh-CN" altLang="en-US" i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6207"/>
        <c:crosses val="autoZero"/>
        <c:crossBetween val="between"/>
        <c:majorUnit val="4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B$46</c:f>
              <c:strCache>
                <c:ptCount val="1"/>
                <c:pt idx="0">
                  <c:v>LAC2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M$46:$U$46</c:f>
                <c:numCache>
                  <c:formatCode>General</c:formatCode>
                  <c:ptCount val="9"/>
                  <c:pt idx="1">
                    <c:v>0</c:v>
                  </c:pt>
                  <c:pt idx="2">
                    <c:v>4.0147816982071136E-2</c:v>
                  </c:pt>
                  <c:pt idx="3">
                    <c:v>0</c:v>
                  </c:pt>
                  <c:pt idx="4">
                    <c:v>2.8983410378060386E-2</c:v>
                  </c:pt>
                  <c:pt idx="5">
                    <c:v>5.0103874135056618E-3</c:v>
                  </c:pt>
                  <c:pt idx="6">
                    <c:v>6.9158876498423685E-2</c:v>
                  </c:pt>
                  <c:pt idx="7">
                    <c:v>5.0970489055587598E-3</c:v>
                  </c:pt>
                  <c:pt idx="8">
                    <c:v>2.2537384128601939E-2</c:v>
                  </c:pt>
                </c:numCache>
              </c:numRef>
            </c:plus>
            <c:minus>
              <c:numRef>
                <c:f>Sheet7!$M$46:$U$46</c:f>
                <c:numCache>
                  <c:formatCode>General</c:formatCode>
                  <c:ptCount val="9"/>
                  <c:pt idx="1">
                    <c:v>0</c:v>
                  </c:pt>
                  <c:pt idx="2">
                    <c:v>4.0147816982071136E-2</c:v>
                  </c:pt>
                  <c:pt idx="3">
                    <c:v>0</c:v>
                  </c:pt>
                  <c:pt idx="4">
                    <c:v>2.8983410378060386E-2</c:v>
                  </c:pt>
                  <c:pt idx="5">
                    <c:v>5.0103874135056618E-3</c:v>
                  </c:pt>
                  <c:pt idx="6">
                    <c:v>6.9158876498423685E-2</c:v>
                  </c:pt>
                  <c:pt idx="7">
                    <c:v>5.0970489055587598E-3</c:v>
                  </c:pt>
                  <c:pt idx="8">
                    <c:v>2.25373841286019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7!$C$41:$K$42</c:f>
              <c:multiLvlStrCache>
                <c:ptCount val="9"/>
                <c:lvl>
                  <c:pt idx="1">
                    <c:v>100 mM</c:v>
                  </c:pt>
                  <c:pt idx="2">
                    <c:v>500 mM</c:v>
                  </c:pt>
                  <c:pt idx="3">
                    <c:v>100 mM</c:v>
                  </c:pt>
                  <c:pt idx="4">
                    <c:v>500 mM</c:v>
                  </c:pt>
                  <c:pt idx="5">
                    <c:v>100 mM</c:v>
                  </c:pt>
                  <c:pt idx="6">
                    <c:v>500 mM</c:v>
                  </c:pt>
                  <c:pt idx="7">
                    <c:v>100 mM</c:v>
                  </c:pt>
                  <c:pt idx="8">
                    <c:v>500 mM</c:v>
                  </c:pt>
                </c:lvl>
                <c:lvl>
                  <c:pt idx="0">
                    <c:v>Mock</c:v>
                  </c:pt>
                  <c:pt idx="1">
                    <c:v>Cu</c:v>
                  </c:pt>
                  <c:pt idx="3">
                    <c:v>Ni </c:v>
                  </c:pt>
                  <c:pt idx="5">
                    <c:v>Fe</c:v>
                  </c:pt>
                  <c:pt idx="7">
                    <c:v>Cd</c:v>
                  </c:pt>
                </c:lvl>
              </c:multiLvlStrCache>
            </c:multiLvlStrRef>
          </c:cat>
          <c:val>
            <c:numRef>
              <c:f>Sheet7!$C$46:$K$46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.27272142947360534</c:v>
                </c:pt>
                <c:pt idx="3">
                  <c:v>0</c:v>
                </c:pt>
                <c:pt idx="4">
                  <c:v>0.17712862193370632</c:v>
                </c:pt>
                <c:pt idx="5">
                  <c:v>3.4953782215280067E-2</c:v>
                </c:pt>
                <c:pt idx="6">
                  <c:v>0.23991255455325369</c:v>
                </c:pt>
                <c:pt idx="7">
                  <c:v>1.7557506242749731E-2</c:v>
                </c:pt>
                <c:pt idx="8">
                  <c:v>6.281171491802504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3A-401F-A904-AA7CB54CEB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2646207"/>
        <c:axId val="2082647039"/>
      </c:barChart>
      <c:catAx>
        <c:axId val="2082646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7039"/>
        <c:crosses val="autoZero"/>
        <c:auto val="1"/>
        <c:lblAlgn val="ctr"/>
        <c:lblOffset val="100"/>
        <c:noMultiLvlLbl val="0"/>
      </c:catAx>
      <c:valAx>
        <c:axId val="2082647039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Normalized</a:t>
                </a:r>
                <a:r>
                  <a:rPr lang="en-US" altLang="zh-CN" baseline="0"/>
                  <a:t> expression level of </a:t>
                </a:r>
                <a:r>
                  <a:rPr lang="en-US" altLang="zh-CN" i="1" baseline="0"/>
                  <a:t>PvLac20</a:t>
                </a:r>
                <a:endParaRPr lang="zh-CN" altLang="en-US" i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6207"/>
        <c:crosses val="autoZero"/>
        <c:crossBetween val="between"/>
        <c:majorUnit val="0.1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B$47</c:f>
              <c:strCache>
                <c:ptCount val="1"/>
                <c:pt idx="0">
                  <c:v>LAC3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M$47:$U$47</c:f>
                <c:numCache>
                  <c:formatCode>General</c:formatCode>
                  <c:ptCount val="9"/>
                  <c:pt idx="0">
                    <c:v>1.8556140797006637E-2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22810375473380937</c:v>
                  </c:pt>
                  <c:pt idx="5">
                    <c:v>1.6842297730181539E-2</c:v>
                  </c:pt>
                  <c:pt idx="6">
                    <c:v>0.10185699159678557</c:v>
                  </c:pt>
                  <c:pt idx="7">
                    <c:v>2.2465368401224536E-2</c:v>
                  </c:pt>
                  <c:pt idx="8">
                    <c:v>0.16741040689708522</c:v>
                  </c:pt>
                </c:numCache>
              </c:numRef>
            </c:plus>
            <c:minus>
              <c:numRef>
                <c:f>Sheet7!$M$47:$U$47</c:f>
                <c:numCache>
                  <c:formatCode>General</c:formatCode>
                  <c:ptCount val="9"/>
                  <c:pt idx="0">
                    <c:v>1.8556140797006637E-2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22810375473380937</c:v>
                  </c:pt>
                  <c:pt idx="5">
                    <c:v>1.6842297730181539E-2</c:v>
                  </c:pt>
                  <c:pt idx="6">
                    <c:v>0.10185699159678557</c:v>
                  </c:pt>
                  <c:pt idx="7">
                    <c:v>2.2465368401224536E-2</c:v>
                  </c:pt>
                  <c:pt idx="8">
                    <c:v>0.167410406897085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7!$C$41:$K$42</c:f>
              <c:multiLvlStrCache>
                <c:ptCount val="9"/>
                <c:lvl>
                  <c:pt idx="1">
                    <c:v>100 mM</c:v>
                  </c:pt>
                  <c:pt idx="2">
                    <c:v>500 mM</c:v>
                  </c:pt>
                  <c:pt idx="3">
                    <c:v>100 mM</c:v>
                  </c:pt>
                  <c:pt idx="4">
                    <c:v>500 mM</c:v>
                  </c:pt>
                  <c:pt idx="5">
                    <c:v>100 mM</c:v>
                  </c:pt>
                  <c:pt idx="6">
                    <c:v>500 mM</c:v>
                  </c:pt>
                  <c:pt idx="7">
                    <c:v>100 mM</c:v>
                  </c:pt>
                  <c:pt idx="8">
                    <c:v>500 mM</c:v>
                  </c:pt>
                </c:lvl>
                <c:lvl>
                  <c:pt idx="0">
                    <c:v>Mock</c:v>
                  </c:pt>
                  <c:pt idx="1">
                    <c:v>Cu</c:v>
                  </c:pt>
                  <c:pt idx="3">
                    <c:v>Ni </c:v>
                  </c:pt>
                  <c:pt idx="5">
                    <c:v>Fe</c:v>
                  </c:pt>
                  <c:pt idx="7">
                    <c:v>Cd</c:v>
                  </c:pt>
                </c:lvl>
              </c:multiLvlStrCache>
            </c:multiLvlStrRef>
          </c:cat>
          <c:val>
            <c:numRef>
              <c:f>Sheet7!$C$47:$K$47</c:f>
              <c:numCache>
                <c:formatCode>General</c:formatCode>
                <c:ptCount val="9"/>
                <c:pt idx="0">
                  <c:v>8.5156071122073226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73233252498204404</c:v>
                </c:pt>
                <c:pt idx="5">
                  <c:v>9.4193252593979163E-2</c:v>
                </c:pt>
                <c:pt idx="6">
                  <c:v>0.3580906042231059</c:v>
                </c:pt>
                <c:pt idx="7">
                  <c:v>0.22980295608456502</c:v>
                </c:pt>
                <c:pt idx="8">
                  <c:v>0.848171413254187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D4-4A31-B0CC-B5C8D34EBF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2646207"/>
        <c:axId val="2082647039"/>
      </c:barChart>
      <c:catAx>
        <c:axId val="2082646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7039"/>
        <c:crosses val="autoZero"/>
        <c:auto val="1"/>
        <c:lblAlgn val="ctr"/>
        <c:lblOffset val="100"/>
        <c:noMultiLvlLbl val="0"/>
      </c:catAx>
      <c:valAx>
        <c:axId val="2082647039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/>
                  <a:t>Normalized</a:t>
                </a:r>
                <a:r>
                  <a:rPr lang="en-US" altLang="zh-CN" baseline="0"/>
                  <a:t> expression level of </a:t>
                </a:r>
                <a:r>
                  <a:rPr lang="en-US" altLang="zh-CN" i="1" baseline="0"/>
                  <a:t>PvLac30</a:t>
                </a:r>
                <a:endParaRPr lang="zh-CN" altLang="en-US" i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2646207"/>
        <c:crosses val="autoZero"/>
        <c:crossBetween val="between"/>
        <c:majorUnit val="0.25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9</c:f>
              <c:strCache>
                <c:ptCount val="1"/>
                <c:pt idx="0">
                  <c:v>PvCOM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B$19:$M$19</c:f>
                <c:numCache>
                  <c:formatCode>General</c:formatCode>
                  <c:ptCount val="12"/>
                  <c:pt idx="0">
                    <c:v>8.0509641281282001E-6</c:v>
                  </c:pt>
                  <c:pt idx="1">
                    <c:v>2.8355920315530702E-5</c:v>
                  </c:pt>
                  <c:pt idx="2">
                    <c:v>1.7029067691448501E-5</c:v>
                  </c:pt>
                  <c:pt idx="3">
                    <c:v>2.5818343535384499E-5</c:v>
                  </c:pt>
                  <c:pt idx="4">
                    <c:v>7.7415297946984504E-6</c:v>
                  </c:pt>
                  <c:pt idx="5">
                    <c:v>3.1789208553447099E-6</c:v>
                  </c:pt>
                  <c:pt idx="6">
                    <c:v>5.6768111846644102E-7</c:v>
                  </c:pt>
                  <c:pt idx="7">
                    <c:v>4.5902901338830502E-7</c:v>
                  </c:pt>
                  <c:pt idx="8">
                    <c:v>9.8867956751496195E-6</c:v>
                  </c:pt>
                  <c:pt idx="9">
                    <c:v>6.1655489250236297E-6</c:v>
                  </c:pt>
                  <c:pt idx="10">
                    <c:v>8.2284910413363204E-6</c:v>
                  </c:pt>
                  <c:pt idx="11">
                    <c:v>2.0527079417440301E-6</c:v>
                  </c:pt>
                </c:numCache>
              </c:numRef>
            </c:plus>
            <c:minus>
              <c:numRef>
                <c:f>Sheet3!$B$19:$M$19</c:f>
                <c:numCache>
                  <c:formatCode>General</c:formatCode>
                  <c:ptCount val="12"/>
                  <c:pt idx="0">
                    <c:v>8.0509641281282001E-6</c:v>
                  </c:pt>
                  <c:pt idx="1">
                    <c:v>2.8355920315530702E-5</c:v>
                  </c:pt>
                  <c:pt idx="2">
                    <c:v>1.7029067691448501E-5</c:v>
                  </c:pt>
                  <c:pt idx="3">
                    <c:v>2.5818343535384499E-5</c:v>
                  </c:pt>
                  <c:pt idx="4">
                    <c:v>7.7415297946984504E-6</c:v>
                  </c:pt>
                  <c:pt idx="5">
                    <c:v>3.1789208553447099E-6</c:v>
                  </c:pt>
                  <c:pt idx="6">
                    <c:v>5.6768111846644102E-7</c:v>
                  </c:pt>
                  <c:pt idx="7">
                    <c:v>4.5902901338830502E-7</c:v>
                  </c:pt>
                  <c:pt idx="8">
                    <c:v>9.8867956751496195E-6</c:v>
                  </c:pt>
                  <c:pt idx="9">
                    <c:v>6.1655489250236297E-6</c:v>
                  </c:pt>
                  <c:pt idx="10">
                    <c:v>8.2284910413363204E-6</c:v>
                  </c:pt>
                  <c:pt idx="11">
                    <c:v>2.0527079417440301E-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B$2:$M$3</c:f>
              <c:strCache>
                <c:ptCount val="12"/>
                <c:pt idx="0">
                  <c:v>E4I1</c:v>
                </c:pt>
                <c:pt idx="1">
                  <c:v>E4I2</c:v>
                </c:pt>
                <c:pt idx="2">
                  <c:v>E4I3</c:v>
                </c:pt>
                <c:pt idx="3">
                  <c:v>E4I4</c:v>
                </c:pt>
                <c:pt idx="4">
                  <c:v>E4L1</c:v>
                </c:pt>
                <c:pt idx="5">
                  <c:v>E4L2</c:v>
                </c:pt>
                <c:pt idx="6">
                  <c:v>E4L3</c:v>
                </c:pt>
                <c:pt idx="7">
                  <c:v>E4L4</c:v>
                </c:pt>
                <c:pt idx="8">
                  <c:v>E4LS1</c:v>
                </c:pt>
                <c:pt idx="9">
                  <c:v>E4LS2</c:v>
                </c:pt>
                <c:pt idx="10">
                  <c:v>E4LS3</c:v>
                </c:pt>
                <c:pt idx="11">
                  <c:v>E4LS4</c:v>
                </c:pt>
              </c:strCache>
            </c:strRef>
          </c:cat>
          <c:val>
            <c:numRef>
              <c:f>Sheet3!$B$9:$M$9</c:f>
              <c:numCache>
                <c:formatCode>General</c:formatCode>
                <c:ptCount val="12"/>
                <c:pt idx="0">
                  <c:v>4.4104874864488598E-4</c:v>
                </c:pt>
                <c:pt idx="1">
                  <c:v>2.0358441779137201E-4</c:v>
                </c:pt>
                <c:pt idx="2">
                  <c:v>2.9112672707144402E-4</c:v>
                </c:pt>
                <c:pt idx="3">
                  <c:v>2.3586245939009401E-4</c:v>
                </c:pt>
                <c:pt idx="4">
                  <c:v>5.1803617911477402E-5</c:v>
                </c:pt>
                <c:pt idx="5">
                  <c:v>1.6327132592692402E-5</c:v>
                </c:pt>
                <c:pt idx="6">
                  <c:v>7.4558577769735299E-6</c:v>
                </c:pt>
                <c:pt idx="7">
                  <c:v>3.4217811603782399E-6</c:v>
                </c:pt>
                <c:pt idx="8">
                  <c:v>1.01612821559781E-4</c:v>
                </c:pt>
                <c:pt idx="9">
                  <c:v>5.7793095852534698E-5</c:v>
                </c:pt>
                <c:pt idx="10">
                  <c:v>5.9575885783257098E-5</c:v>
                </c:pt>
                <c:pt idx="11">
                  <c:v>2.8614830115213199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51-4460-A937-6E0E26958F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714160"/>
        <c:axId val="793734960"/>
      </c:barChart>
      <c:catAx>
        <c:axId val="793714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34960"/>
        <c:crosses val="autoZero"/>
        <c:auto val="1"/>
        <c:lblAlgn val="ctr"/>
        <c:lblOffset val="100"/>
        <c:noMultiLvlLbl val="0"/>
      </c:catAx>
      <c:valAx>
        <c:axId val="793734960"/>
        <c:scaling>
          <c:orientation val="minMax"/>
          <c:max val="5.9999999999999995E-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 dirty="0"/>
                  <a:t>Relative</a:t>
                </a:r>
                <a:r>
                  <a:rPr lang="en-US" altLang="zh-CN" sz="1200" baseline="0" dirty="0"/>
                  <a:t> expression of </a:t>
                </a:r>
                <a:r>
                  <a:rPr lang="en-US" altLang="zh-CN" sz="1200" i="1" baseline="0" dirty="0" err="1"/>
                  <a:t>PvCOMT</a:t>
                </a:r>
                <a:endParaRPr lang="zh-CN" altLang="en-US" sz="1200" i="1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14160"/>
        <c:crosses val="autoZero"/>
        <c:crossBetween val="between"/>
        <c:majorUnit val="1.4999999999999999E-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00">
          <a:latin typeface="Times New Roman" panose="02020603050405020304" charset="0"/>
          <a:cs typeface="Times New Roman" panose="0202060305040502030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4</c:f>
              <c:strCache>
                <c:ptCount val="1"/>
                <c:pt idx="0">
                  <c:v>PvLac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B$14:$M$14</c:f>
                <c:numCache>
                  <c:formatCode>General</c:formatCode>
                  <c:ptCount val="12"/>
                  <c:pt idx="0">
                    <c:v>9.1518714412512105E-4</c:v>
                  </c:pt>
                  <c:pt idx="1">
                    <c:v>3.2540888850522099E-3</c:v>
                  </c:pt>
                  <c:pt idx="2">
                    <c:v>3.8698184189860899E-3</c:v>
                  </c:pt>
                  <c:pt idx="3">
                    <c:v>3.0928981271681798E-3</c:v>
                  </c:pt>
                  <c:pt idx="4">
                    <c:v>1.4134305155854799E-3</c:v>
                  </c:pt>
                  <c:pt idx="5">
                    <c:v>7.1598619810423305E-4</c:v>
                  </c:pt>
                  <c:pt idx="6">
                    <c:v>5.6601060944542895E-4</c:v>
                  </c:pt>
                  <c:pt idx="7">
                    <c:v>1.34175775098309E-3</c:v>
                  </c:pt>
                  <c:pt idx="8">
                    <c:v>5.7142538645100604E-4</c:v>
                  </c:pt>
                  <c:pt idx="9">
                    <c:v>9.0871961507770296E-4</c:v>
                  </c:pt>
                  <c:pt idx="10">
                    <c:v>1.8807133916927101E-4</c:v>
                  </c:pt>
                  <c:pt idx="11">
                    <c:v>1.16930669438388E-4</c:v>
                  </c:pt>
                </c:numCache>
              </c:numRef>
            </c:plus>
            <c:minus>
              <c:numRef>
                <c:f>Sheet3!$B$14:$M$14</c:f>
                <c:numCache>
                  <c:formatCode>General</c:formatCode>
                  <c:ptCount val="12"/>
                  <c:pt idx="0">
                    <c:v>9.1518714412512105E-4</c:v>
                  </c:pt>
                  <c:pt idx="1">
                    <c:v>3.2540888850522099E-3</c:v>
                  </c:pt>
                  <c:pt idx="2">
                    <c:v>3.8698184189860899E-3</c:v>
                  </c:pt>
                  <c:pt idx="3">
                    <c:v>3.0928981271681798E-3</c:v>
                  </c:pt>
                  <c:pt idx="4">
                    <c:v>1.4134305155854799E-3</c:v>
                  </c:pt>
                  <c:pt idx="5">
                    <c:v>7.1598619810423305E-4</c:v>
                  </c:pt>
                  <c:pt idx="6">
                    <c:v>5.6601060944542895E-4</c:v>
                  </c:pt>
                  <c:pt idx="7">
                    <c:v>1.34175775098309E-3</c:v>
                  </c:pt>
                  <c:pt idx="8">
                    <c:v>5.7142538645100604E-4</c:v>
                  </c:pt>
                  <c:pt idx="9">
                    <c:v>9.0871961507770296E-4</c:v>
                  </c:pt>
                  <c:pt idx="10">
                    <c:v>1.8807133916927101E-4</c:v>
                  </c:pt>
                  <c:pt idx="11">
                    <c:v>1.16930669438388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B$2:$M$3</c:f>
              <c:strCache>
                <c:ptCount val="12"/>
                <c:pt idx="0">
                  <c:v>E4I1</c:v>
                </c:pt>
                <c:pt idx="1">
                  <c:v>E4I2</c:v>
                </c:pt>
                <c:pt idx="2">
                  <c:v>E4I3</c:v>
                </c:pt>
                <c:pt idx="3">
                  <c:v>E4I4</c:v>
                </c:pt>
                <c:pt idx="4">
                  <c:v>E4L1</c:v>
                </c:pt>
                <c:pt idx="5">
                  <c:v>E4L2</c:v>
                </c:pt>
                <c:pt idx="6">
                  <c:v>E4L3</c:v>
                </c:pt>
                <c:pt idx="7">
                  <c:v>E4L4</c:v>
                </c:pt>
                <c:pt idx="8">
                  <c:v>E4LS1</c:v>
                </c:pt>
                <c:pt idx="9">
                  <c:v>E4LS2</c:v>
                </c:pt>
                <c:pt idx="10">
                  <c:v>E4LS3</c:v>
                </c:pt>
                <c:pt idx="11">
                  <c:v>E4LS4</c:v>
                </c:pt>
              </c:strCache>
            </c:strRef>
          </c:cat>
          <c:val>
            <c:numRef>
              <c:f>Sheet3!$B$4:$M$4</c:f>
              <c:numCache>
                <c:formatCode>General</c:formatCode>
                <c:ptCount val="12"/>
                <c:pt idx="0">
                  <c:v>3.55197400880349E-2</c:v>
                </c:pt>
                <c:pt idx="1">
                  <c:v>3.4657018841467602E-2</c:v>
                </c:pt>
                <c:pt idx="2">
                  <c:v>2.62231697874852E-2</c:v>
                </c:pt>
                <c:pt idx="3">
                  <c:v>9.8911754100356603E-3</c:v>
                </c:pt>
                <c:pt idx="4">
                  <c:v>9.0431347166164307E-3</c:v>
                </c:pt>
                <c:pt idx="5">
                  <c:v>6.5505720556757602E-3</c:v>
                </c:pt>
                <c:pt idx="6">
                  <c:v>4.8278611179136503E-3</c:v>
                </c:pt>
                <c:pt idx="7">
                  <c:v>5.0667270238929701E-3</c:v>
                </c:pt>
                <c:pt idx="8">
                  <c:v>7.5344001679793398E-3</c:v>
                </c:pt>
                <c:pt idx="9">
                  <c:v>3.5842284180938101E-3</c:v>
                </c:pt>
                <c:pt idx="10">
                  <c:v>2.18412590358454E-3</c:v>
                </c:pt>
                <c:pt idx="11">
                  <c:v>2.19037226155170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BB-48CC-B9CE-49BF894591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714160"/>
        <c:axId val="793734960"/>
      </c:barChart>
      <c:catAx>
        <c:axId val="793714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34960"/>
        <c:crosses val="autoZero"/>
        <c:auto val="1"/>
        <c:lblAlgn val="ctr"/>
        <c:lblOffset val="100"/>
        <c:noMultiLvlLbl val="0"/>
      </c:catAx>
      <c:valAx>
        <c:axId val="793734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of </a:t>
                </a:r>
              </a:p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 i="1" baseline="0"/>
                  <a:t>PvLac2</a:t>
                </a:r>
                <a:endParaRPr lang="zh-CN" altLang="en-US" sz="1200" i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14160"/>
        <c:crosses val="autoZero"/>
        <c:crossBetween val="between"/>
        <c:majorUnit val="0.0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00">
          <a:latin typeface="Times New Roman" panose="02020603050405020304" charset="0"/>
          <a:cs typeface="Times New Roman" panose="0202060305040502030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5</c:f>
              <c:strCache>
                <c:ptCount val="1"/>
                <c:pt idx="0">
                  <c:v>PvLac14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B$15:$M$15</c:f>
                <c:numCache>
                  <c:formatCode>General</c:formatCode>
                  <c:ptCount val="12"/>
                  <c:pt idx="0">
                    <c:v>3.24161486242835E-3</c:v>
                  </c:pt>
                  <c:pt idx="1">
                    <c:v>9.3157075938794603E-4</c:v>
                  </c:pt>
                  <c:pt idx="2">
                    <c:v>2.1295140485189301E-3</c:v>
                  </c:pt>
                  <c:pt idx="3">
                    <c:v>2.1664162761259799E-4</c:v>
                  </c:pt>
                  <c:pt idx="4">
                    <c:v>2.02196319969722E-4</c:v>
                  </c:pt>
                  <c:pt idx="5">
                    <c:v>5.9787591014203901E-5</c:v>
                  </c:pt>
                  <c:pt idx="6">
                    <c:v>6.4699214719600605E-5</c:v>
                  </c:pt>
                  <c:pt idx="7">
                    <c:v>6.5600958716931901E-5</c:v>
                  </c:pt>
                  <c:pt idx="8">
                    <c:v>1.2303339585897601E-4</c:v>
                  </c:pt>
                  <c:pt idx="9">
                    <c:v>1.68262490010868E-5</c:v>
                  </c:pt>
                  <c:pt idx="10">
                    <c:v>1.0507456961905901E-5</c:v>
                  </c:pt>
                  <c:pt idx="11">
                    <c:v>3.1968628412429702E-6</c:v>
                  </c:pt>
                </c:numCache>
              </c:numRef>
            </c:plus>
            <c:minus>
              <c:numRef>
                <c:f>Sheet3!$B$15:$M$15</c:f>
                <c:numCache>
                  <c:formatCode>General</c:formatCode>
                  <c:ptCount val="12"/>
                  <c:pt idx="0">
                    <c:v>3.24161486242835E-3</c:v>
                  </c:pt>
                  <c:pt idx="1">
                    <c:v>9.3157075938794603E-4</c:v>
                  </c:pt>
                  <c:pt idx="2">
                    <c:v>2.1295140485189301E-3</c:v>
                  </c:pt>
                  <c:pt idx="3">
                    <c:v>2.1664162761259799E-4</c:v>
                  </c:pt>
                  <c:pt idx="4">
                    <c:v>2.02196319969722E-4</c:v>
                  </c:pt>
                  <c:pt idx="5">
                    <c:v>5.9787591014203901E-5</c:v>
                  </c:pt>
                  <c:pt idx="6">
                    <c:v>6.4699214719600605E-5</c:v>
                  </c:pt>
                  <c:pt idx="7">
                    <c:v>6.5600958716931901E-5</c:v>
                  </c:pt>
                  <c:pt idx="8">
                    <c:v>1.2303339585897601E-4</c:v>
                  </c:pt>
                  <c:pt idx="9">
                    <c:v>1.68262490010868E-5</c:v>
                  </c:pt>
                  <c:pt idx="10">
                    <c:v>1.0507456961905901E-5</c:v>
                  </c:pt>
                  <c:pt idx="11">
                    <c:v>3.1968628412429702E-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B$2:$M$3</c:f>
              <c:strCache>
                <c:ptCount val="12"/>
                <c:pt idx="0">
                  <c:v>E4I1</c:v>
                </c:pt>
                <c:pt idx="1">
                  <c:v>E4I2</c:v>
                </c:pt>
                <c:pt idx="2">
                  <c:v>E4I3</c:v>
                </c:pt>
                <c:pt idx="3">
                  <c:v>E4I4</c:v>
                </c:pt>
                <c:pt idx="4">
                  <c:v>E4L1</c:v>
                </c:pt>
                <c:pt idx="5">
                  <c:v>E4L2</c:v>
                </c:pt>
                <c:pt idx="6">
                  <c:v>E4L3</c:v>
                </c:pt>
                <c:pt idx="7">
                  <c:v>E4L4</c:v>
                </c:pt>
                <c:pt idx="8">
                  <c:v>E4LS1</c:v>
                </c:pt>
                <c:pt idx="9">
                  <c:v>E4LS2</c:v>
                </c:pt>
                <c:pt idx="10">
                  <c:v>E4LS3</c:v>
                </c:pt>
                <c:pt idx="11">
                  <c:v>E4LS4</c:v>
                </c:pt>
              </c:strCache>
            </c:strRef>
          </c:cat>
          <c:val>
            <c:numRef>
              <c:f>Sheet3!$B$5:$M$5</c:f>
              <c:numCache>
                <c:formatCode>General</c:formatCode>
                <c:ptCount val="12"/>
                <c:pt idx="0">
                  <c:v>8.1284213464353407E-3</c:v>
                </c:pt>
                <c:pt idx="1">
                  <c:v>8.1931475655553001E-3</c:v>
                </c:pt>
                <c:pt idx="2">
                  <c:v>1.67082865645953E-2</c:v>
                </c:pt>
                <c:pt idx="3">
                  <c:v>9.6261700056222304E-4</c:v>
                </c:pt>
                <c:pt idx="4">
                  <c:v>5.6700751214935397E-4</c:v>
                </c:pt>
                <c:pt idx="5">
                  <c:v>2.2875606151837499E-4</c:v>
                </c:pt>
                <c:pt idx="6">
                  <c:v>5.3838155622598703E-4</c:v>
                </c:pt>
                <c:pt idx="7">
                  <c:v>3.4817067394551801E-4</c:v>
                </c:pt>
                <c:pt idx="8">
                  <c:v>4.4127790418644301E-4</c:v>
                </c:pt>
                <c:pt idx="9">
                  <c:v>1.3192065139508899E-4</c:v>
                </c:pt>
                <c:pt idx="10">
                  <c:v>3.3910866605580298E-4</c:v>
                </c:pt>
                <c:pt idx="11">
                  <c:v>2.329003948234830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89-457A-A252-15EBDB4FC9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714160"/>
        <c:axId val="793734960"/>
      </c:barChart>
      <c:catAx>
        <c:axId val="793714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34960"/>
        <c:crosses val="autoZero"/>
        <c:auto val="1"/>
        <c:lblAlgn val="ctr"/>
        <c:lblOffset val="100"/>
        <c:noMultiLvlLbl val="0"/>
      </c:catAx>
      <c:valAx>
        <c:axId val="793734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of</a:t>
                </a:r>
              </a:p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 baseline="0"/>
                  <a:t> </a:t>
                </a:r>
                <a:r>
                  <a:rPr lang="en-US" altLang="zh-CN" sz="1200" i="1" baseline="0"/>
                  <a:t>PvLac14</a:t>
                </a:r>
                <a:endParaRPr lang="zh-CN" altLang="en-US" sz="1200" i="1"/>
              </a:p>
            </c:rich>
          </c:tx>
          <c:layout>
            <c:manualLayout>
              <c:xMode val="edge"/>
              <c:yMode val="edge"/>
              <c:x val="4.9780864197530854E-2"/>
              <c:y val="9.419166666666667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14160"/>
        <c:crosses val="autoZero"/>
        <c:crossBetween val="between"/>
        <c:majorUnit val="5.0000000000000001E-3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00">
          <a:latin typeface="Times New Roman" panose="02020603050405020304" charset="0"/>
          <a:cs typeface="Times New Roman" panose="0202060305040502030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$6</c:f>
              <c:strCache>
                <c:ptCount val="1"/>
                <c:pt idx="0">
                  <c:v>PvLac17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B$16:$M$16</c:f>
                <c:numCache>
                  <c:formatCode>General</c:formatCode>
                  <c:ptCount val="12"/>
                  <c:pt idx="0">
                    <c:v>1.13488173190521E-2</c:v>
                  </c:pt>
                  <c:pt idx="1">
                    <c:v>7.7255666222915903E-3</c:v>
                  </c:pt>
                  <c:pt idx="2">
                    <c:v>7.8148106833221594E-3</c:v>
                  </c:pt>
                  <c:pt idx="3">
                    <c:v>6.25478718974484E-3</c:v>
                  </c:pt>
                  <c:pt idx="4">
                    <c:v>1.05542532935073E-4</c:v>
                  </c:pt>
                  <c:pt idx="5">
                    <c:v>4.9147866981631499E-4</c:v>
                  </c:pt>
                  <c:pt idx="6">
                    <c:v>2.0545384905198399E-4</c:v>
                  </c:pt>
                  <c:pt idx="7">
                    <c:v>8.2729689344636099E-4</c:v>
                  </c:pt>
                  <c:pt idx="8">
                    <c:v>1.3470072704046101E-2</c:v>
                  </c:pt>
                  <c:pt idx="9">
                    <c:v>1.3872197438833601E-2</c:v>
                  </c:pt>
                  <c:pt idx="10">
                    <c:v>7.5025116074296603E-3</c:v>
                  </c:pt>
                  <c:pt idx="11">
                    <c:v>7.7189470730740697E-3</c:v>
                  </c:pt>
                </c:numCache>
              </c:numRef>
            </c:plus>
            <c:minus>
              <c:numRef>
                <c:f>Sheet3!$B$16:$M$16</c:f>
                <c:numCache>
                  <c:formatCode>General</c:formatCode>
                  <c:ptCount val="12"/>
                  <c:pt idx="0">
                    <c:v>1.13488173190521E-2</c:v>
                  </c:pt>
                  <c:pt idx="1">
                    <c:v>7.7255666222915903E-3</c:v>
                  </c:pt>
                  <c:pt idx="2">
                    <c:v>7.8148106833221594E-3</c:v>
                  </c:pt>
                  <c:pt idx="3">
                    <c:v>6.25478718974484E-3</c:v>
                  </c:pt>
                  <c:pt idx="4">
                    <c:v>1.05542532935073E-4</c:v>
                  </c:pt>
                  <c:pt idx="5">
                    <c:v>4.9147866981631499E-4</c:v>
                  </c:pt>
                  <c:pt idx="6">
                    <c:v>2.0545384905198399E-4</c:v>
                  </c:pt>
                  <c:pt idx="7">
                    <c:v>8.2729689344636099E-4</c:v>
                  </c:pt>
                  <c:pt idx="8">
                    <c:v>1.3470072704046101E-2</c:v>
                  </c:pt>
                  <c:pt idx="9">
                    <c:v>1.3872197438833601E-2</c:v>
                  </c:pt>
                  <c:pt idx="10">
                    <c:v>7.5025116074296603E-3</c:v>
                  </c:pt>
                  <c:pt idx="11">
                    <c:v>7.718947073074069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B$2:$M$3</c:f>
              <c:strCache>
                <c:ptCount val="12"/>
                <c:pt idx="0">
                  <c:v>E4I1</c:v>
                </c:pt>
                <c:pt idx="1">
                  <c:v>E4I2</c:v>
                </c:pt>
                <c:pt idx="2">
                  <c:v>E4I3</c:v>
                </c:pt>
                <c:pt idx="3">
                  <c:v>E4I4</c:v>
                </c:pt>
                <c:pt idx="4">
                  <c:v>E4L1</c:v>
                </c:pt>
                <c:pt idx="5">
                  <c:v>E4L2</c:v>
                </c:pt>
                <c:pt idx="6">
                  <c:v>E4L3</c:v>
                </c:pt>
                <c:pt idx="7">
                  <c:v>E4L4</c:v>
                </c:pt>
                <c:pt idx="8">
                  <c:v>E4LS1</c:v>
                </c:pt>
                <c:pt idx="9">
                  <c:v>E4LS2</c:v>
                </c:pt>
                <c:pt idx="10">
                  <c:v>E4LS3</c:v>
                </c:pt>
                <c:pt idx="11">
                  <c:v>E4LS4</c:v>
                </c:pt>
              </c:strCache>
            </c:strRef>
          </c:cat>
          <c:val>
            <c:numRef>
              <c:f>Sheet3!$B$6:$M$6</c:f>
              <c:numCache>
                <c:formatCode>General</c:formatCode>
                <c:ptCount val="12"/>
                <c:pt idx="0">
                  <c:v>0.14201418532848201</c:v>
                </c:pt>
                <c:pt idx="1">
                  <c:v>0.117653132016471</c:v>
                </c:pt>
                <c:pt idx="2">
                  <c:v>0.12501917402155099</c:v>
                </c:pt>
                <c:pt idx="3">
                  <c:v>0.120430812230492</c:v>
                </c:pt>
                <c:pt idx="4">
                  <c:v>1.8010220214771801E-3</c:v>
                </c:pt>
                <c:pt idx="5">
                  <c:v>1.8791877646163601E-3</c:v>
                </c:pt>
                <c:pt idx="6">
                  <c:v>2.8275915716876499E-3</c:v>
                </c:pt>
                <c:pt idx="7">
                  <c:v>4.0359727181730198E-3</c:v>
                </c:pt>
                <c:pt idx="8">
                  <c:v>0.13806744973200599</c:v>
                </c:pt>
                <c:pt idx="9">
                  <c:v>0.114662092188775</c:v>
                </c:pt>
                <c:pt idx="10">
                  <c:v>7.5668785522907803E-2</c:v>
                </c:pt>
                <c:pt idx="11">
                  <c:v>9.179490919102370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CA-4C37-9137-BE20808373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714160"/>
        <c:axId val="793734960"/>
      </c:barChart>
      <c:catAx>
        <c:axId val="793714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34960"/>
        <c:crosses val="autoZero"/>
        <c:auto val="1"/>
        <c:lblAlgn val="ctr"/>
        <c:lblOffset val="100"/>
        <c:noMultiLvlLbl val="0"/>
      </c:catAx>
      <c:valAx>
        <c:axId val="793734960"/>
        <c:scaling>
          <c:orientation val="minMax"/>
          <c:max val="0.1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/>
                  <a:t>Relative</a:t>
                </a:r>
                <a:r>
                  <a:rPr lang="en-US" altLang="zh-CN" sz="1200" baseline="0"/>
                  <a:t> expression of </a:t>
                </a:r>
              </a:p>
              <a:p>
                <a:pPr>
                  <a:defRPr lang="zh-CN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charset="0"/>
                    <a:ea typeface="+mn-ea"/>
                    <a:cs typeface="Times New Roman" panose="02020603050405020304" charset="0"/>
                  </a:defRPr>
                </a:pPr>
                <a:r>
                  <a:rPr lang="en-US" altLang="zh-CN" sz="1200" i="1" baseline="0"/>
                  <a:t>PvLac17</a:t>
                </a:r>
                <a:endParaRPr lang="zh-CN" altLang="en-US" sz="1200" i="1"/>
              </a:p>
            </c:rich>
          </c:tx>
          <c:layout>
            <c:manualLayout>
              <c:xMode val="edge"/>
              <c:yMode val="edge"/>
              <c:x val="4.3117283950617286E-2"/>
              <c:y val="5.64444444444444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charset="0"/>
                  <a:ea typeface="+mn-ea"/>
                  <a:cs typeface="Times New Roman" panose="0202060305040502030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en-US"/>
          </a:p>
        </c:txPr>
        <c:crossAx val="793714160"/>
        <c:crosses val="autoZero"/>
        <c:crossBetween val="between"/>
        <c:majorUnit val="0.0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1000">
          <a:latin typeface="Times New Roman" panose="02020603050405020304" charset="0"/>
          <a:cs typeface="Times New Roman" panose="0202060305040502030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899100" y="914400"/>
            <a:ext cx="73494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899100" y="3560400"/>
            <a:ext cx="73494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456300" y="774000"/>
            <a:ext cx="82296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899100" y="2484000"/>
            <a:ext cx="73494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899100" y="3560400"/>
            <a:ext cx="73494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456300" y="1490400"/>
            <a:ext cx="82269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493100" y="3848400"/>
            <a:ext cx="58266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493100" y="4615200"/>
            <a:ext cx="58266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456300" y="1501200"/>
            <a:ext cx="38826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808700" y="1501200"/>
            <a:ext cx="38826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456300" y="1429200"/>
            <a:ext cx="40068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56300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4676813" y="1421729"/>
            <a:ext cx="40068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4676813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456248" y="1555115"/>
            <a:ext cx="3924776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4762800" y="1555200"/>
            <a:ext cx="39204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6/1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7676100" y="914400"/>
            <a:ext cx="783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85800" y="914400"/>
            <a:ext cx="68769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456300" y="608400"/>
            <a:ext cx="82269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456300" y="1490400"/>
            <a:ext cx="82269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4590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2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3087000" y="6314400"/>
            <a:ext cx="297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66582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5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0.xml"/><Relationship Id="rId3" Type="http://schemas.openxmlformats.org/officeDocument/2006/relationships/notesSlide" Target="../notesSlides/notesSlide1.xml"/><Relationship Id="rId7" Type="http://schemas.openxmlformats.org/officeDocument/2006/relationships/chart" Target="../charts/chart9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6.xml"/><Relationship Id="rId6" Type="http://schemas.openxmlformats.org/officeDocument/2006/relationships/chart" Target="../charts/chart8.xml"/><Relationship Id="rId11" Type="http://schemas.openxmlformats.org/officeDocument/2006/relationships/image" Target="../media/image6.png"/><Relationship Id="rId5" Type="http://schemas.openxmlformats.org/officeDocument/2006/relationships/chart" Target="../charts/chart7.xml"/><Relationship Id="rId10" Type="http://schemas.openxmlformats.org/officeDocument/2006/relationships/chart" Target="../charts/chart12.xml"/><Relationship Id="rId4" Type="http://schemas.openxmlformats.org/officeDocument/2006/relationships/chart" Target="../charts/chart6.xml"/><Relationship Id="rId9" Type="http://schemas.openxmlformats.org/officeDocument/2006/relationships/chart" Target="../charts/chart1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1E0645A-B6EA-4C30-A622-B0C7E337CF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9193" y="1654994"/>
            <a:ext cx="1733550" cy="215265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8996369-68BF-4AD4-A3CF-4962DD65026A}"/>
              </a:ext>
            </a:extLst>
          </p:cNvPr>
          <p:cNvSpPr txBox="1"/>
          <p:nvPr/>
        </p:nvSpPr>
        <p:spPr>
          <a:xfrm>
            <a:off x="5359191" y="3997510"/>
            <a:ext cx="17335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0039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8EEC906D-A126-4955-81FC-27E0A38D79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3249" y="1654994"/>
            <a:ext cx="1733550" cy="2166937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5D4F8B4C-164F-488A-A5B3-ED5359FC3C3A}"/>
              </a:ext>
            </a:extLst>
          </p:cNvPr>
          <p:cNvSpPr txBox="1"/>
          <p:nvPr/>
        </p:nvSpPr>
        <p:spPr>
          <a:xfrm>
            <a:off x="3443249" y="3980217"/>
            <a:ext cx="1695049" cy="3835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0773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4DF81C94-703B-4C2E-B644-85215C34CDD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28304" y="1654994"/>
            <a:ext cx="1832553" cy="215265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AF2DF7E4-6B75-46F2-908A-9C980A5EA462}"/>
              </a:ext>
            </a:extLst>
          </p:cNvPr>
          <p:cNvSpPr txBox="1"/>
          <p:nvPr/>
        </p:nvSpPr>
        <p:spPr>
          <a:xfrm>
            <a:off x="1389804" y="3978444"/>
            <a:ext cx="1695049" cy="3835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0773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DBF7F4C-ACFF-4555-AC62-E982FD901B01}"/>
              </a:ext>
            </a:extLst>
          </p:cNvPr>
          <p:cNvSpPr txBox="1"/>
          <p:nvPr/>
        </p:nvSpPr>
        <p:spPr>
          <a:xfrm>
            <a:off x="112394" y="154940"/>
            <a:ext cx="8694721" cy="340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1.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The structure of copper oxidase domains. 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ata from NCBI (https://www.ncbi.nlm.nih.gov/Structure/cdd/).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200" kern="100" dirty="0">
              <a:effectLst/>
              <a:latin typeface="Palatino Linotype" panose="0204050205050503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4527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图片 107">
            <a:extLst>
              <a:ext uri="{FF2B5EF4-FFF2-40B4-BE49-F238E27FC236}">
                <a16:creationId xmlns:a16="http://schemas.microsoft.com/office/drawing/2014/main" id="{2D4D7C6D-B883-825E-3979-F689A3C9E17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137"/>
          <a:stretch/>
        </p:blipFill>
        <p:spPr>
          <a:xfrm>
            <a:off x="217714" y="529771"/>
            <a:ext cx="8708572" cy="6437086"/>
          </a:xfrm>
          <a:prstGeom prst="rect">
            <a:avLst/>
          </a:prstGeom>
        </p:spPr>
      </p:pic>
      <p:sp>
        <p:nvSpPr>
          <p:cNvPr id="109" name="文本框 108">
            <a:extLst>
              <a:ext uri="{FF2B5EF4-FFF2-40B4-BE49-F238E27FC236}">
                <a16:creationId xmlns:a16="http://schemas.microsoft.com/office/drawing/2014/main" id="{7BEFCBBB-91E7-9AF6-9CCC-D27E1EE252AF}"/>
              </a:ext>
            </a:extLst>
          </p:cNvPr>
          <p:cNvSpPr txBox="1"/>
          <p:nvPr/>
        </p:nvSpPr>
        <p:spPr>
          <a:xfrm>
            <a:off x="146731" y="3919856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C684C7EE-7E7A-06EE-FB20-E1C6A32DBA29}"/>
              </a:ext>
            </a:extLst>
          </p:cNvPr>
          <p:cNvSpPr txBox="1"/>
          <p:nvPr/>
        </p:nvSpPr>
        <p:spPr>
          <a:xfrm>
            <a:off x="146731" y="661922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FEC7C972-83DF-AC8C-F80F-A6680EC1A9DA}"/>
              </a:ext>
            </a:extLst>
          </p:cNvPr>
          <p:cNvSpPr txBox="1"/>
          <p:nvPr/>
        </p:nvSpPr>
        <p:spPr>
          <a:xfrm>
            <a:off x="146731" y="68106"/>
            <a:ext cx="829627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b="1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200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Synteny analysis of </a:t>
            </a:r>
            <a:r>
              <a:rPr lang="en-US" altLang="zh-CN" sz="1200" i="1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LAC</a:t>
            </a:r>
            <a:r>
              <a:rPr lang="en-US" altLang="zh-CN" sz="1200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 genes between 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witchgrass</a:t>
            </a:r>
            <a:r>
              <a:rPr lang="en-US" altLang="zh-CN" sz="1200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 and </a:t>
            </a:r>
            <a:r>
              <a:rPr lang="en-US" altLang="zh-CN" sz="1200" i="1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Arabidopsis</a:t>
            </a:r>
            <a:r>
              <a:rPr lang="en-US" altLang="zh-CN" sz="1200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s well as</a:t>
            </a:r>
            <a:r>
              <a:rPr lang="en-US" altLang="zh-CN" sz="1200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 rice. </a:t>
            </a:r>
          </a:p>
          <a:p>
            <a:pPr algn="l"/>
            <a:r>
              <a:rPr lang="en-US" altLang="zh-CN" sz="1200" b="0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The red lines represented collinearity relationship between (a) switchgrass and </a:t>
            </a:r>
            <a:r>
              <a:rPr lang="en-US" altLang="zh-CN" sz="1200" b="0" i="1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Arabidopsis</a:t>
            </a:r>
            <a:r>
              <a:rPr lang="en-US" altLang="zh-CN" sz="1200" b="0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, (b) switchgrass and rice. Gene names are listed according to their chromosomal location. </a:t>
            </a:r>
          </a:p>
        </p:txBody>
      </p:sp>
    </p:spTree>
    <p:extLst>
      <p:ext uri="{BB962C8B-B14F-4D97-AF65-F5344CB8AC3E}">
        <p14:creationId xmlns:p14="http://schemas.microsoft.com/office/powerpoint/2010/main" val="1779734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12395" y="154940"/>
            <a:ext cx="7627620" cy="340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1200" b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3.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alysis of </a:t>
            </a:r>
            <a:r>
              <a:rPr lang="en-US" altLang="zh-CN" sz="1200" i="1" kern="100" dirty="0" err="1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romoters.</a:t>
            </a:r>
            <a:endParaRPr lang="zh-CN" altLang="zh-CN" sz="1200" kern="100" dirty="0">
              <a:effectLst/>
              <a:latin typeface="Palatino Linotype" panose="0204050205050503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 descr="0605顺式作用元件1 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395" y="619760"/>
            <a:ext cx="8971915" cy="5617845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12394" y="154940"/>
            <a:ext cx="8331199" cy="8940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1200" b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4.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Expression of </a:t>
            </a:r>
            <a:r>
              <a:rPr lang="en-US" altLang="zh-CN" sz="1200" i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s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fter cold, drought and heavy metal treatments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a) Relative change fold of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2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14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17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fter cold and drought treatments; (b) Normalized expression level of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16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25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20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30 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fter heavy metal treatments. ND, data not determined.</a:t>
            </a:r>
            <a:endParaRPr lang="zh-CN" altLang="zh-CN" sz="1200" kern="100" dirty="0">
              <a:effectLst/>
              <a:latin typeface="Palatino Linotype" panose="0204050205050503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8A8A7FB-5A20-46E2-B92E-161E79BE51D8}"/>
              </a:ext>
            </a:extLst>
          </p:cNvPr>
          <p:cNvSpPr txBox="1"/>
          <p:nvPr/>
        </p:nvSpPr>
        <p:spPr>
          <a:xfrm>
            <a:off x="197065" y="3005455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75B146C-DAF1-47ED-8697-7D51F415E9E8}"/>
              </a:ext>
            </a:extLst>
          </p:cNvPr>
          <p:cNvSpPr txBox="1"/>
          <p:nvPr/>
        </p:nvSpPr>
        <p:spPr>
          <a:xfrm>
            <a:off x="197065" y="1098150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67818EFE-D8FD-470E-B907-220A5039356F}"/>
              </a:ext>
            </a:extLst>
          </p:cNvPr>
          <p:cNvGrpSpPr/>
          <p:nvPr/>
        </p:nvGrpSpPr>
        <p:grpSpPr>
          <a:xfrm>
            <a:off x="851320" y="1064906"/>
            <a:ext cx="4227195" cy="2500619"/>
            <a:chOff x="700405" y="1068081"/>
            <a:chExt cx="4572000" cy="2701925"/>
          </a:xfrm>
        </p:grpSpPr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64D3BD62-48D3-4D1A-9DA6-9C92A49BA980}"/>
                </a:ext>
              </a:extLst>
            </p:cNvPr>
            <p:cNvCxnSpPr>
              <a:cxnSpLocks/>
            </p:cNvCxnSpPr>
            <p:nvPr/>
          </p:nvCxnSpPr>
          <p:spPr>
            <a:xfrm>
              <a:off x="1462768" y="1204899"/>
              <a:ext cx="0" cy="1614522"/>
            </a:xfrm>
            <a:prstGeom prst="line">
              <a:avLst/>
            </a:prstGeom>
            <a:ln w="190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aphicFrame>
          <p:nvGraphicFramePr>
            <p:cNvPr id="9" name="图表 8">
              <a:extLst>
                <a:ext uri="{FF2B5EF4-FFF2-40B4-BE49-F238E27FC236}">
                  <a16:creationId xmlns:a16="http://schemas.microsoft.com/office/drawing/2014/main" id="{755AE58C-AC6C-4555-89ED-ECD89C7CE53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06258551"/>
                </p:ext>
              </p:extLst>
            </p:nvPr>
          </p:nvGraphicFramePr>
          <p:xfrm>
            <a:off x="700405" y="1068081"/>
            <a:ext cx="4572000" cy="27019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aphicFrame>
        <p:nvGraphicFramePr>
          <p:cNvPr id="11" name="图表 10">
            <a:extLst>
              <a:ext uri="{FF2B5EF4-FFF2-40B4-BE49-F238E27FC236}">
                <a16:creationId xmlns:a16="http://schemas.microsoft.com/office/drawing/2014/main" id="{B6D36CE9-A418-4F9B-BE8D-22F1018380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089859"/>
              </p:ext>
            </p:extLst>
          </p:nvPr>
        </p:nvGraphicFramePr>
        <p:xfrm>
          <a:off x="-12700" y="3275618"/>
          <a:ext cx="45847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图表 11">
            <a:extLst>
              <a:ext uri="{FF2B5EF4-FFF2-40B4-BE49-F238E27FC236}">
                <a16:creationId xmlns:a16="http://schemas.microsoft.com/office/drawing/2014/main" id="{255D8E04-CCC1-456E-B3D9-8A2FD573C8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520643"/>
              </p:ext>
            </p:extLst>
          </p:nvPr>
        </p:nvGraphicFramePr>
        <p:xfrm>
          <a:off x="-9525" y="5004729"/>
          <a:ext cx="4581525" cy="17968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图表 14">
            <a:extLst>
              <a:ext uri="{FF2B5EF4-FFF2-40B4-BE49-F238E27FC236}">
                <a16:creationId xmlns:a16="http://schemas.microsoft.com/office/drawing/2014/main" id="{090D834F-60F9-480D-B0BB-48D1364DD5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4065426"/>
              </p:ext>
            </p:extLst>
          </p:nvPr>
        </p:nvGraphicFramePr>
        <p:xfrm>
          <a:off x="4368585" y="3297774"/>
          <a:ext cx="4581525" cy="1790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6" name="文本框 15">
            <a:extLst>
              <a:ext uri="{FF2B5EF4-FFF2-40B4-BE49-F238E27FC236}">
                <a16:creationId xmlns:a16="http://schemas.microsoft.com/office/drawing/2014/main" id="{0D19820E-FD06-4CC5-920C-9DE95539EDD8}"/>
              </a:ext>
            </a:extLst>
          </p:cNvPr>
          <p:cNvSpPr txBox="1"/>
          <p:nvPr/>
        </p:nvSpPr>
        <p:spPr>
          <a:xfrm>
            <a:off x="5289765" y="4138958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986EEB5-D37B-4696-B716-59EBFA0F6843}"/>
              </a:ext>
            </a:extLst>
          </p:cNvPr>
          <p:cNvSpPr txBox="1"/>
          <p:nvPr/>
        </p:nvSpPr>
        <p:spPr>
          <a:xfrm>
            <a:off x="5659862" y="4138958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9C90CA5-99C7-43D3-B515-210A6A78C93F}"/>
              </a:ext>
            </a:extLst>
          </p:cNvPr>
          <p:cNvSpPr txBox="1"/>
          <p:nvPr/>
        </p:nvSpPr>
        <p:spPr>
          <a:xfrm>
            <a:off x="6460699" y="4138958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9" name="图表 18">
            <a:extLst>
              <a:ext uri="{FF2B5EF4-FFF2-40B4-BE49-F238E27FC236}">
                <a16:creationId xmlns:a16="http://schemas.microsoft.com/office/drawing/2014/main" id="{DBAC0093-5DE7-49B1-A3FB-BAFA66E6D2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4696630"/>
              </p:ext>
            </p:extLst>
          </p:nvPr>
        </p:nvGraphicFramePr>
        <p:xfrm>
          <a:off x="4346781" y="5035411"/>
          <a:ext cx="4578350" cy="1793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" name="文本框 19">
            <a:extLst>
              <a:ext uri="{FF2B5EF4-FFF2-40B4-BE49-F238E27FC236}">
                <a16:creationId xmlns:a16="http://schemas.microsoft.com/office/drawing/2014/main" id="{0FA22E1F-7ACE-430D-82B6-7E2AF06BBF8F}"/>
              </a:ext>
            </a:extLst>
          </p:cNvPr>
          <p:cNvSpPr txBox="1"/>
          <p:nvPr/>
        </p:nvSpPr>
        <p:spPr>
          <a:xfrm>
            <a:off x="5702569" y="5874152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B54E222-E998-4B66-BB37-B90E1159F5CC}"/>
              </a:ext>
            </a:extLst>
          </p:cNvPr>
          <p:cNvSpPr txBox="1"/>
          <p:nvPr/>
        </p:nvSpPr>
        <p:spPr>
          <a:xfrm>
            <a:off x="6072666" y="5874152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795143C-0493-4F01-A2E3-ADEE00316DCC}"/>
              </a:ext>
            </a:extLst>
          </p:cNvPr>
          <p:cNvSpPr txBox="1"/>
          <p:nvPr/>
        </p:nvSpPr>
        <p:spPr>
          <a:xfrm>
            <a:off x="6496895" y="5874151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674148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2"/>
          <p:cNvSpPr txBox="1">
            <a:spLocks noChangeArrowheads="1"/>
          </p:cNvSpPr>
          <p:nvPr/>
        </p:nvSpPr>
        <p:spPr bwMode="auto">
          <a:xfrm>
            <a:off x="-14520" y="-145650"/>
            <a:ext cx="8560435" cy="1172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1200" b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5.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issue specific 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xpression pattern of </a:t>
            </a:r>
            <a:r>
              <a:rPr lang="en-US" altLang="zh-CN" sz="1200" i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s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lignin staining of E4 stage switchgrass internodes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a) Tissue specific expression pattern of </a:t>
            </a:r>
            <a:r>
              <a:rPr lang="en-US" altLang="zh-CN" sz="1200" i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vLacs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long the internodes and leaves of E4 stage switchgrass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and (b)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gnin staining of different internodes of E4 stage switchgrass. Bar = 500 </a:t>
            </a:r>
            <a:r>
              <a:rPr lang="en-US" altLang="zh-CN" sz="1200" kern="100" dirty="0" err="1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I, L and LS stands for internode, leaf blade and leaf sheath, respectively.</a:t>
            </a:r>
            <a:endParaRPr lang="zh-CN" altLang="zh-CN" sz="1200" kern="100" dirty="0">
              <a:effectLst/>
              <a:latin typeface="Palatino Linotype" panose="0204050205050503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0F0B45ED-1E16-45F8-93B9-E1E9DDC11334}"/>
              </a:ext>
            </a:extLst>
          </p:cNvPr>
          <p:cNvGrpSpPr/>
          <p:nvPr/>
        </p:nvGrpSpPr>
        <p:grpSpPr>
          <a:xfrm>
            <a:off x="378372" y="985213"/>
            <a:ext cx="6087108" cy="6023704"/>
            <a:chOff x="-14520" y="307858"/>
            <a:chExt cx="6480000" cy="6375405"/>
          </a:xfrm>
        </p:grpSpPr>
        <p:graphicFrame>
          <p:nvGraphicFramePr>
            <p:cNvPr id="2" name="图表 1"/>
            <p:cNvGraphicFramePr/>
            <p:nvPr>
              <p:extLst>
                <p:ext uri="{D42A27DB-BD31-4B8C-83A1-F6EECF244321}">
                  <p14:modId xmlns:p14="http://schemas.microsoft.com/office/powerpoint/2010/main" val="463477100"/>
                </p:ext>
              </p:extLst>
            </p:nvPr>
          </p:nvGraphicFramePr>
          <p:xfrm>
            <a:off x="-14520" y="307858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956E1502-0DFE-4509-BB5C-414885A3AB49}"/>
                </a:ext>
              </a:extLst>
            </p:cNvPr>
            <p:cNvGrpSpPr/>
            <p:nvPr/>
          </p:nvGrpSpPr>
          <p:grpSpPr>
            <a:xfrm>
              <a:off x="0" y="1933121"/>
              <a:ext cx="6425014" cy="4750142"/>
              <a:chOff x="0" y="1933121"/>
              <a:chExt cx="6425014" cy="4750142"/>
            </a:xfrm>
          </p:grpSpPr>
          <p:graphicFrame>
            <p:nvGraphicFramePr>
              <p:cNvPr id="3" name="图表 2"/>
              <p:cNvGraphicFramePr/>
              <p:nvPr>
                <p:extLst>
                  <p:ext uri="{D42A27DB-BD31-4B8C-83A1-F6EECF244321}">
                    <p14:modId xmlns:p14="http://schemas.microsoft.com/office/powerpoint/2010/main" val="3144344056"/>
                  </p:ext>
                </p:extLst>
              </p:nvPr>
            </p:nvGraphicFramePr>
            <p:xfrm>
              <a:off x="0" y="1933121"/>
              <a:ext cx="3240000" cy="164883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5" name="图表 4"/>
              <p:cNvGraphicFramePr/>
              <p:nvPr>
                <p:extLst>
                  <p:ext uri="{D42A27DB-BD31-4B8C-83A1-F6EECF244321}">
                    <p14:modId xmlns:p14="http://schemas.microsoft.com/office/powerpoint/2010/main" val="2705821887"/>
                  </p:ext>
                </p:extLst>
              </p:nvPr>
            </p:nvGraphicFramePr>
            <p:xfrm>
              <a:off x="3177194" y="1933121"/>
              <a:ext cx="3240000" cy="164883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6" name="图表 5"/>
              <p:cNvGraphicFramePr/>
              <p:nvPr>
                <p:extLst>
                  <p:ext uri="{D42A27DB-BD31-4B8C-83A1-F6EECF244321}">
                    <p14:modId xmlns:p14="http://schemas.microsoft.com/office/powerpoint/2010/main" val="1748766051"/>
                  </p:ext>
                </p:extLst>
              </p:nvPr>
            </p:nvGraphicFramePr>
            <p:xfrm>
              <a:off x="651" y="3409163"/>
              <a:ext cx="3240000" cy="164883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aphicFrame>
            <p:nvGraphicFramePr>
              <p:cNvPr id="7" name="图表 6"/>
              <p:cNvGraphicFramePr/>
              <p:nvPr>
                <p:extLst>
                  <p:ext uri="{D42A27DB-BD31-4B8C-83A1-F6EECF244321}">
                    <p14:modId xmlns:p14="http://schemas.microsoft.com/office/powerpoint/2010/main" val="2022010658"/>
                  </p:ext>
                </p:extLst>
              </p:nvPr>
            </p:nvGraphicFramePr>
            <p:xfrm>
              <a:off x="3185014" y="3423310"/>
              <a:ext cx="3240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9" name="图表 8"/>
              <p:cNvGraphicFramePr/>
              <p:nvPr>
                <p:extLst>
                  <p:ext uri="{D42A27DB-BD31-4B8C-83A1-F6EECF244321}">
                    <p14:modId xmlns:p14="http://schemas.microsoft.com/office/powerpoint/2010/main" val="1919075557"/>
                  </p:ext>
                </p:extLst>
              </p:nvPr>
            </p:nvGraphicFramePr>
            <p:xfrm>
              <a:off x="0" y="4883263"/>
              <a:ext cx="3240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</p:grpSp>
        <p:graphicFrame>
          <p:nvGraphicFramePr>
            <p:cNvPr id="10" name="图表 9"/>
            <p:cNvGraphicFramePr/>
            <p:nvPr>
              <p:extLst>
                <p:ext uri="{D42A27DB-BD31-4B8C-83A1-F6EECF244321}">
                  <p14:modId xmlns:p14="http://schemas.microsoft.com/office/powerpoint/2010/main" val="1104607089"/>
                </p:ext>
              </p:extLst>
            </p:nvPr>
          </p:nvGraphicFramePr>
          <p:xfrm>
            <a:off x="3225480" y="307858"/>
            <a:ext cx="324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C66F538F-6998-41E3-8603-85B00133567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609873" y="686801"/>
            <a:ext cx="2097577" cy="6159915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36083A95-1418-48D6-9215-3F38F5D43EE7}"/>
              </a:ext>
            </a:extLst>
          </p:cNvPr>
          <p:cNvSpPr txBox="1"/>
          <p:nvPr/>
        </p:nvSpPr>
        <p:spPr>
          <a:xfrm>
            <a:off x="6302827" y="590437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22CEFAD-51B7-497D-9F1C-5067459CBF25}"/>
              </a:ext>
            </a:extLst>
          </p:cNvPr>
          <p:cNvSpPr txBox="1"/>
          <p:nvPr/>
        </p:nvSpPr>
        <p:spPr>
          <a:xfrm>
            <a:off x="140342" y="1075388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A36C4F0-A427-4285-B54F-A81A4B374A3B}"/>
              </a:ext>
            </a:extLst>
          </p:cNvPr>
          <p:cNvSpPr txBox="1"/>
          <p:nvPr/>
        </p:nvSpPr>
        <p:spPr>
          <a:xfrm>
            <a:off x="6573747" y="708214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4I1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6D3185D-277C-4656-9CF7-A3D8A15C1F9F}"/>
              </a:ext>
            </a:extLst>
          </p:cNvPr>
          <p:cNvSpPr txBox="1"/>
          <p:nvPr/>
        </p:nvSpPr>
        <p:spPr>
          <a:xfrm>
            <a:off x="6573747" y="2253105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4I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EBBECD9-8366-407F-9E1A-1CE7E6CEBCE4}"/>
              </a:ext>
            </a:extLst>
          </p:cNvPr>
          <p:cNvSpPr txBox="1"/>
          <p:nvPr/>
        </p:nvSpPr>
        <p:spPr>
          <a:xfrm>
            <a:off x="6573747" y="3797996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4I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12C8C0A-44DA-45FE-8034-F504C8918A1C}"/>
              </a:ext>
            </a:extLst>
          </p:cNvPr>
          <p:cNvSpPr txBox="1"/>
          <p:nvPr/>
        </p:nvSpPr>
        <p:spPr>
          <a:xfrm>
            <a:off x="6573747" y="5342888"/>
            <a:ext cx="503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4I4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>
            <a:extLst>
              <a:ext uri="{FF2B5EF4-FFF2-40B4-BE49-F238E27FC236}">
                <a16:creationId xmlns:a16="http://schemas.microsoft.com/office/drawing/2014/main" id="{1588EC91-9630-4B5A-BA70-17854CB2C76D}"/>
              </a:ext>
            </a:extLst>
          </p:cNvPr>
          <p:cNvSpPr txBox="1"/>
          <p:nvPr/>
        </p:nvSpPr>
        <p:spPr>
          <a:xfrm>
            <a:off x="119586" y="206076"/>
            <a:ext cx="8112739" cy="8951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i="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1200" b="1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6.</a:t>
            </a:r>
            <a:r>
              <a:rPr lang="en-US" altLang="zh-CN" sz="1200" kern="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CL-phloroglucinol staining of switchgrass roots after heavy metal treatments.</a:t>
            </a:r>
            <a:endParaRPr lang="en-US" altLang="zh-CN" sz="1200" kern="100" dirty="0">
              <a:effectLst/>
              <a:latin typeface="Palatino Linotype" panose="0204050205050503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ar = 250 </a:t>
            </a:r>
            <a:r>
              <a:rPr lang="en-US" altLang="zh-CN" sz="1200" kern="100" dirty="0" err="1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effectLst/>
              <a:latin typeface="Palatino Linotype" panose="0204050205050503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zh-CN" altLang="zh-CN" sz="1200" kern="100" dirty="0">
              <a:effectLst/>
              <a:latin typeface="Palatino Linotype" panose="0204050205050503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819995EE-D4F7-1752-F3AE-45A7D545C6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0123"/>
          <a:stretch/>
        </p:blipFill>
        <p:spPr>
          <a:xfrm>
            <a:off x="5259793" y="1961467"/>
            <a:ext cx="3162944" cy="96186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C02C30AB-2FFA-3323-B3D5-4E653D46E7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0055"/>
          <a:stretch/>
        </p:blipFill>
        <p:spPr>
          <a:xfrm>
            <a:off x="474952" y="1970388"/>
            <a:ext cx="4754715" cy="96186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CC03CD59-971C-BFC1-B6A1-C490FC0005CF}"/>
              </a:ext>
            </a:extLst>
          </p:cNvPr>
          <p:cNvSpPr txBox="1"/>
          <p:nvPr/>
        </p:nvSpPr>
        <p:spPr>
          <a:xfrm>
            <a:off x="467881" y="1970388"/>
            <a:ext cx="623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8E89C52-E968-C3D5-1E02-9AF8F5DA0CD3}"/>
              </a:ext>
            </a:extLst>
          </p:cNvPr>
          <p:cNvSpPr txBox="1"/>
          <p:nvPr/>
        </p:nvSpPr>
        <p:spPr>
          <a:xfrm>
            <a:off x="2066723" y="1962169"/>
            <a:ext cx="623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233F70D-8269-826A-98C0-2C1371AD0970}"/>
              </a:ext>
            </a:extLst>
          </p:cNvPr>
          <p:cNvSpPr txBox="1"/>
          <p:nvPr/>
        </p:nvSpPr>
        <p:spPr>
          <a:xfrm>
            <a:off x="3636990" y="1961467"/>
            <a:ext cx="623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EB1B5DF-451F-E1D4-1282-BB994A3721DC}"/>
              </a:ext>
            </a:extLst>
          </p:cNvPr>
          <p:cNvSpPr txBox="1"/>
          <p:nvPr/>
        </p:nvSpPr>
        <p:spPr>
          <a:xfrm>
            <a:off x="5259793" y="1961467"/>
            <a:ext cx="623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C45F3A0-8AC6-A76D-D53E-0562EDF1662F}"/>
              </a:ext>
            </a:extLst>
          </p:cNvPr>
          <p:cNvSpPr txBox="1"/>
          <p:nvPr/>
        </p:nvSpPr>
        <p:spPr>
          <a:xfrm>
            <a:off x="6830060" y="1970389"/>
            <a:ext cx="623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507038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DOCER_TEMPLATE_OPEN_ONCE_MARK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  <p:tag name="KSO_WM_SPECIAL_SOURCE" val="bdnull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  <p:tag name="KSO_WM_SPECIAL_SOURCE" val="bdnull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  <p:tag name="KSO_WM_SPECIAL_SOURCE" val="bdnull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34</Words>
  <Application>Microsoft Office PowerPoint</Application>
  <PresentationFormat>On-screen Show (4:3)</PresentationFormat>
  <Paragraphs>53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Palatino Linotype</vt:lpstr>
      <vt:lpstr>Times New Roman</vt:lpstr>
      <vt:lpstr>Wingdings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eng He</dc:creator>
  <cp:lastModifiedBy>MDPI-48</cp:lastModifiedBy>
  <cp:revision>194</cp:revision>
  <dcterms:created xsi:type="dcterms:W3CDTF">2019-06-19T02:08:00Z</dcterms:created>
  <dcterms:modified xsi:type="dcterms:W3CDTF">2022-06-10T14:17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294</vt:lpwstr>
  </property>
  <property fmtid="{D5CDD505-2E9C-101B-9397-08002B2CF9AE}" pid="3" name="ICV">
    <vt:lpwstr>A08F71FA34384772A1BAAC9CDDC58D66</vt:lpwstr>
  </property>
</Properties>
</file>